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21D35-C37D-4540-9C86-8E33644BAF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501E5-0AAC-4C2D-816F-CFA69169C4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E9BB2F-2FCC-4CA9-976C-CDD291605B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893DBF-CE15-4A5B-B6FE-6A3EBBE686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80012-3084-4F5A-A216-402FED2199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D622F7-D0CF-466C-8337-D8B4125F88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1F07D-64B4-46EE-83B4-3946515FEC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9C0A6-F3A8-4A15-BA77-22F99C7CA4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4D1D0-3F27-4CA7-ABDA-BB8AC2DDEC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5E0D76-B7F9-4697-9CAD-4E68A42A30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7392A-A843-4142-BDCC-B5A01E7ED8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B2C14-0B9B-4598-97EC-B449499EB9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9000"/>
          </a:bodyPr>
          <a:p>
            <a:pPr marL="305280" indent="-3052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660960" indent="-2541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017000" indent="-2034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424160" indent="-2034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830960" indent="-2034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830960" indent="-2034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830960" indent="-2034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7A2388-4B78-4113-951A-A9C5701C4D5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2043360" y="258840"/>
            <a:ext cx="5029560" cy="2887200"/>
            <a:chOff x="2043360" y="258840"/>
            <a:chExt cx="5029560" cy="2887200"/>
          </a:xfrm>
        </p:grpSpPr>
        <p:sp>
          <p:nvSpPr>
            <p:cNvPr id="42" name="Rectangle 96"/>
            <p:cNvSpPr/>
            <p:nvPr/>
          </p:nvSpPr>
          <p:spPr>
            <a:xfrm>
              <a:off x="2918160" y="1158480"/>
              <a:ext cx="538200" cy="15210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Rectangle 103"/>
            <p:cNvSpPr/>
            <p:nvPr/>
          </p:nvSpPr>
          <p:spPr>
            <a:xfrm>
              <a:off x="3720960" y="1140840"/>
              <a:ext cx="538200" cy="15386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Line 100"/>
            <p:cNvSpPr/>
            <p:nvPr/>
          </p:nvSpPr>
          <p:spPr>
            <a:xfrm>
              <a:off x="3049560" y="954720"/>
              <a:ext cx="258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Line 102"/>
            <p:cNvSpPr/>
            <p:nvPr/>
          </p:nvSpPr>
          <p:spPr>
            <a:xfrm>
              <a:off x="3180960" y="954720"/>
              <a:ext cx="1080" cy="186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Line 107"/>
            <p:cNvSpPr/>
            <p:nvPr/>
          </p:nvSpPr>
          <p:spPr>
            <a:xfrm>
              <a:off x="3852360" y="933120"/>
              <a:ext cx="25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Line 109"/>
            <p:cNvSpPr/>
            <p:nvPr/>
          </p:nvSpPr>
          <p:spPr>
            <a:xfrm>
              <a:off x="3985200" y="933120"/>
              <a:ext cx="1080" cy="188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Rectangle 112"/>
            <p:cNvSpPr/>
            <p:nvPr/>
          </p:nvSpPr>
          <p:spPr>
            <a:xfrm>
              <a:off x="2865240" y="2779920"/>
              <a:ext cx="575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Rectangle 114"/>
            <p:cNvSpPr/>
            <p:nvPr/>
          </p:nvSpPr>
          <p:spPr>
            <a:xfrm>
              <a:off x="3670200" y="2719440"/>
              <a:ext cx="614880" cy="42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NO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eated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Line 115"/>
            <p:cNvSpPr/>
            <p:nvPr/>
          </p:nvSpPr>
          <p:spPr>
            <a:xfrm flipV="1">
              <a:off x="2665800" y="915120"/>
              <a:ext cx="2520" cy="1756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Line 116"/>
            <p:cNvSpPr/>
            <p:nvPr/>
          </p:nvSpPr>
          <p:spPr>
            <a:xfrm flipH="1">
              <a:off x="2630880" y="2671920"/>
              <a:ext cx="34560" cy="2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Rectangle 117"/>
            <p:cNvSpPr/>
            <p:nvPr/>
          </p:nvSpPr>
          <p:spPr>
            <a:xfrm>
              <a:off x="2488680" y="256824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Line 118"/>
            <p:cNvSpPr/>
            <p:nvPr/>
          </p:nvSpPr>
          <p:spPr>
            <a:xfrm flipH="1">
              <a:off x="2630880" y="2231640"/>
              <a:ext cx="345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Rectangle 119"/>
            <p:cNvSpPr/>
            <p:nvPr/>
          </p:nvSpPr>
          <p:spPr>
            <a:xfrm>
              <a:off x="2488680" y="213048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Line 120"/>
            <p:cNvSpPr/>
            <p:nvPr/>
          </p:nvSpPr>
          <p:spPr>
            <a:xfrm flipH="1">
              <a:off x="2630880" y="1794960"/>
              <a:ext cx="345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Rectangle 121"/>
            <p:cNvSpPr/>
            <p:nvPr/>
          </p:nvSpPr>
          <p:spPr>
            <a:xfrm>
              <a:off x="2488680" y="168984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Line 122"/>
            <p:cNvSpPr/>
            <p:nvPr/>
          </p:nvSpPr>
          <p:spPr>
            <a:xfrm flipH="1">
              <a:off x="2630880" y="1354680"/>
              <a:ext cx="34560" cy="2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Rectangle 123"/>
            <p:cNvSpPr/>
            <p:nvPr/>
          </p:nvSpPr>
          <p:spPr>
            <a:xfrm>
              <a:off x="2488680" y="125208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Line 124"/>
            <p:cNvSpPr/>
            <p:nvPr/>
          </p:nvSpPr>
          <p:spPr>
            <a:xfrm flipH="1">
              <a:off x="2630880" y="915480"/>
              <a:ext cx="34560" cy="2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Rectangle 125"/>
            <p:cNvSpPr/>
            <p:nvPr/>
          </p:nvSpPr>
          <p:spPr>
            <a:xfrm>
              <a:off x="2488680" y="81180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Rectangle 135"/>
            <p:cNvSpPr/>
            <p:nvPr/>
          </p:nvSpPr>
          <p:spPr>
            <a:xfrm>
              <a:off x="2043360" y="2588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1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Rectangle 164"/>
            <p:cNvSpPr/>
            <p:nvPr/>
          </p:nvSpPr>
          <p:spPr>
            <a:xfrm rot="16200000">
              <a:off x="1698840" y="1712520"/>
              <a:ext cx="116964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NKA I</a:t>
              </a:r>
              <a:r>
                <a:rPr b="0" lang="en-US" sz="14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p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pA/pF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Rectangle 141"/>
            <p:cNvSpPr/>
            <p:nvPr/>
          </p:nvSpPr>
          <p:spPr>
            <a:xfrm>
              <a:off x="5706000" y="1447920"/>
              <a:ext cx="539640" cy="12290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Rectangle 148"/>
            <p:cNvSpPr/>
            <p:nvPr/>
          </p:nvSpPr>
          <p:spPr>
            <a:xfrm>
              <a:off x="6508800" y="1380960"/>
              <a:ext cx="539640" cy="12956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Rectangle 134"/>
            <p:cNvSpPr/>
            <p:nvPr/>
          </p:nvSpPr>
          <p:spPr>
            <a:xfrm>
              <a:off x="4840200" y="2588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1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Line 145"/>
            <p:cNvSpPr/>
            <p:nvPr/>
          </p:nvSpPr>
          <p:spPr>
            <a:xfrm>
              <a:off x="5838840" y="1281600"/>
              <a:ext cx="25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Line 152"/>
            <p:cNvSpPr/>
            <p:nvPr/>
          </p:nvSpPr>
          <p:spPr>
            <a:xfrm>
              <a:off x="6640200" y="1204920"/>
              <a:ext cx="258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Line 154"/>
            <p:cNvSpPr/>
            <p:nvPr/>
          </p:nvSpPr>
          <p:spPr>
            <a:xfrm>
              <a:off x="6774120" y="1204920"/>
              <a:ext cx="1080" cy="156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Rectangle 155"/>
            <p:cNvSpPr/>
            <p:nvPr/>
          </p:nvSpPr>
          <p:spPr>
            <a:xfrm>
              <a:off x="5657400" y="2777400"/>
              <a:ext cx="575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Rectangle 156"/>
            <p:cNvSpPr/>
            <p:nvPr/>
          </p:nvSpPr>
          <p:spPr>
            <a:xfrm>
              <a:off x="6458040" y="2716920"/>
              <a:ext cx="614880" cy="42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NO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eated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Line 157"/>
            <p:cNvSpPr/>
            <p:nvPr/>
          </p:nvSpPr>
          <p:spPr>
            <a:xfrm flipV="1">
              <a:off x="5453640" y="914400"/>
              <a:ext cx="1080" cy="1752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Line 158"/>
            <p:cNvSpPr/>
            <p:nvPr/>
          </p:nvSpPr>
          <p:spPr>
            <a:xfrm flipH="1">
              <a:off x="5419800" y="2666880"/>
              <a:ext cx="334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Rectangle 159"/>
            <p:cNvSpPr/>
            <p:nvPr/>
          </p:nvSpPr>
          <p:spPr>
            <a:xfrm>
              <a:off x="5279040" y="255024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Line 160"/>
            <p:cNvSpPr/>
            <p:nvPr/>
          </p:nvSpPr>
          <p:spPr>
            <a:xfrm flipH="1">
              <a:off x="5419800" y="1789920"/>
              <a:ext cx="334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Rectangle 161"/>
            <p:cNvSpPr/>
            <p:nvPr/>
          </p:nvSpPr>
          <p:spPr>
            <a:xfrm>
              <a:off x="5279040" y="167472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Line 162"/>
            <p:cNvSpPr/>
            <p:nvPr/>
          </p:nvSpPr>
          <p:spPr>
            <a:xfrm flipH="1">
              <a:off x="5419800" y="914400"/>
              <a:ext cx="334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Rectangle 163"/>
            <p:cNvSpPr/>
            <p:nvPr/>
          </p:nvSpPr>
          <p:spPr>
            <a:xfrm>
              <a:off x="5279040" y="79776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Rectangle 164"/>
            <p:cNvSpPr/>
            <p:nvPr/>
          </p:nvSpPr>
          <p:spPr>
            <a:xfrm rot="16200000">
              <a:off x="4499280" y="1712520"/>
              <a:ext cx="116964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NKA I</a:t>
              </a:r>
              <a:r>
                <a:rPr b="0" lang="en-US" sz="14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p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pA/pF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Line 147"/>
            <p:cNvSpPr/>
            <p:nvPr/>
          </p:nvSpPr>
          <p:spPr>
            <a:xfrm>
              <a:off x="5968800" y="1281600"/>
              <a:ext cx="0" cy="148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0" name="Rectangle 17"/>
          <p:cNvSpPr/>
          <p:nvPr/>
        </p:nvSpPr>
        <p:spPr>
          <a:xfrm>
            <a:off x="6087960" y="4600440"/>
            <a:ext cx="400320" cy="9320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Line 21"/>
          <p:cNvSpPr/>
          <p:nvPr/>
        </p:nvSpPr>
        <p:spPr>
          <a:xfrm>
            <a:off x="6191280" y="4437000"/>
            <a:ext cx="191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Line 23"/>
          <p:cNvSpPr/>
          <p:nvPr/>
        </p:nvSpPr>
        <p:spPr>
          <a:xfrm>
            <a:off x="6286680" y="4437000"/>
            <a:ext cx="2880" cy="163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Rectangle 24"/>
          <p:cNvSpPr/>
          <p:nvPr/>
        </p:nvSpPr>
        <p:spPr>
          <a:xfrm>
            <a:off x="6684840" y="4632480"/>
            <a:ext cx="398520" cy="9000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Line 28"/>
          <p:cNvSpPr/>
          <p:nvPr/>
        </p:nvSpPr>
        <p:spPr>
          <a:xfrm>
            <a:off x="6788160" y="4510080"/>
            <a:ext cx="192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Line 30"/>
          <p:cNvSpPr/>
          <p:nvPr/>
        </p:nvSpPr>
        <p:spPr>
          <a:xfrm>
            <a:off x="6883560" y="4510080"/>
            <a:ext cx="1440" cy="115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Rectangle 37"/>
          <p:cNvSpPr/>
          <p:nvPr/>
        </p:nvSpPr>
        <p:spPr>
          <a:xfrm>
            <a:off x="6041880" y="5116680"/>
            <a:ext cx="486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3SA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Rectangle 39"/>
          <p:cNvSpPr/>
          <p:nvPr/>
        </p:nvSpPr>
        <p:spPr>
          <a:xfrm>
            <a:off x="6450120" y="5116680"/>
            <a:ext cx="89532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  <a:ea typeface="Arial"/>
              </a:rPr>
              <a:t>3SA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Rectangle 143"/>
          <p:cNvSpPr/>
          <p:nvPr/>
        </p:nvSpPr>
        <p:spPr>
          <a:xfrm rot="16200000">
            <a:off x="4474080" y="4367520"/>
            <a:ext cx="1622520" cy="24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KA I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(pA/pF)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Line 40"/>
          <p:cNvSpPr/>
          <p:nvPr/>
        </p:nvSpPr>
        <p:spPr>
          <a:xfrm flipV="1">
            <a:off x="5900760" y="3858840"/>
            <a:ext cx="1440" cy="1668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Line 41"/>
          <p:cNvSpPr/>
          <p:nvPr/>
        </p:nvSpPr>
        <p:spPr>
          <a:xfrm flipH="1">
            <a:off x="5871960" y="5527800"/>
            <a:ext cx="29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Rectangle 42"/>
          <p:cNvSpPr/>
          <p:nvPr/>
        </p:nvSpPr>
        <p:spPr>
          <a:xfrm>
            <a:off x="5535720" y="5403960"/>
            <a:ext cx="434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0.0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Line 43"/>
          <p:cNvSpPr/>
          <p:nvPr/>
        </p:nvSpPr>
        <p:spPr>
          <a:xfrm flipH="1">
            <a:off x="5871960" y="5194440"/>
            <a:ext cx="29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Rectangle 44"/>
          <p:cNvSpPr/>
          <p:nvPr/>
        </p:nvSpPr>
        <p:spPr>
          <a:xfrm>
            <a:off x="5535720" y="5067360"/>
            <a:ext cx="339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Line 45"/>
          <p:cNvSpPr/>
          <p:nvPr/>
        </p:nvSpPr>
        <p:spPr>
          <a:xfrm flipH="1">
            <a:off x="5871960" y="4862520"/>
            <a:ext cx="29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Rectangle 46"/>
          <p:cNvSpPr/>
          <p:nvPr/>
        </p:nvSpPr>
        <p:spPr>
          <a:xfrm>
            <a:off x="5535720" y="4735440"/>
            <a:ext cx="426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Line 47"/>
          <p:cNvSpPr/>
          <p:nvPr/>
        </p:nvSpPr>
        <p:spPr>
          <a:xfrm flipH="1">
            <a:off x="5871960" y="4529160"/>
            <a:ext cx="29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Rectangle 48"/>
          <p:cNvSpPr/>
          <p:nvPr/>
        </p:nvSpPr>
        <p:spPr>
          <a:xfrm>
            <a:off x="5535720" y="4402080"/>
            <a:ext cx="426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Line 49"/>
          <p:cNvSpPr/>
          <p:nvPr/>
        </p:nvSpPr>
        <p:spPr>
          <a:xfrm flipH="1">
            <a:off x="5871960" y="4192560"/>
            <a:ext cx="29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Rectangle 50"/>
          <p:cNvSpPr/>
          <p:nvPr/>
        </p:nvSpPr>
        <p:spPr>
          <a:xfrm>
            <a:off x="5535720" y="4070520"/>
            <a:ext cx="471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2.0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Line 51"/>
          <p:cNvSpPr/>
          <p:nvPr/>
        </p:nvSpPr>
        <p:spPr>
          <a:xfrm flipH="1">
            <a:off x="5871960" y="3859200"/>
            <a:ext cx="29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Rectangle 52"/>
          <p:cNvSpPr/>
          <p:nvPr/>
        </p:nvSpPr>
        <p:spPr>
          <a:xfrm>
            <a:off x="5535720" y="3736800"/>
            <a:ext cx="384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2.5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Rectangle 196"/>
          <p:cNvSpPr/>
          <p:nvPr/>
        </p:nvSpPr>
        <p:spPr>
          <a:xfrm>
            <a:off x="6572880" y="5533920"/>
            <a:ext cx="63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pNO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03" name="Group 1"/>
          <p:cNvGrpSpPr/>
          <p:nvPr/>
        </p:nvGrpSpPr>
        <p:grpSpPr>
          <a:xfrm>
            <a:off x="2895480" y="4287960"/>
            <a:ext cx="2286000" cy="1099080"/>
            <a:chOff x="2895480" y="4287960"/>
            <a:chExt cx="2286000" cy="1099080"/>
          </a:xfrm>
        </p:grpSpPr>
        <p:grpSp>
          <p:nvGrpSpPr>
            <p:cNvPr id="104" name="Group 1"/>
            <p:cNvGrpSpPr/>
            <p:nvPr/>
          </p:nvGrpSpPr>
          <p:grpSpPr>
            <a:xfrm>
              <a:off x="3297240" y="4287960"/>
              <a:ext cx="1722240" cy="663480"/>
              <a:chOff x="3297240" y="4287960"/>
              <a:chExt cx="1722240" cy="663480"/>
            </a:xfrm>
          </p:grpSpPr>
          <p:sp>
            <p:nvSpPr>
              <p:cNvPr id="105" name="Freeform 71"/>
              <p:cNvSpPr/>
              <p:nvPr/>
            </p:nvSpPr>
            <p:spPr>
              <a:xfrm>
                <a:off x="3297240" y="4287960"/>
                <a:ext cx="561240" cy="663480"/>
              </a:xfrm>
              <a:custGeom>
                <a:avLst/>
                <a:gdLst/>
                <a:ahLst/>
                <a:rect l="l" t="t" r="r" b="b"/>
                <a:pathLst>
                  <a:path w="1871" h="418">
                    <a:moveTo>
                      <a:pt x="0" y="177"/>
                    </a:moveTo>
                    <a:lnTo>
                      <a:pt x="0" y="135"/>
                    </a:lnTo>
                    <a:lnTo>
                      <a:pt x="7" y="142"/>
                    </a:lnTo>
                    <a:lnTo>
                      <a:pt x="7" y="149"/>
                    </a:lnTo>
                    <a:lnTo>
                      <a:pt x="14" y="142"/>
                    </a:lnTo>
                    <a:lnTo>
                      <a:pt x="21" y="142"/>
                    </a:lnTo>
                    <a:lnTo>
                      <a:pt x="28" y="142"/>
                    </a:lnTo>
                    <a:lnTo>
                      <a:pt x="28" y="149"/>
                    </a:lnTo>
                    <a:lnTo>
                      <a:pt x="35" y="149"/>
                    </a:lnTo>
                    <a:lnTo>
                      <a:pt x="35" y="142"/>
                    </a:lnTo>
                    <a:lnTo>
                      <a:pt x="43" y="142"/>
                    </a:lnTo>
                    <a:lnTo>
                      <a:pt x="43" y="149"/>
                    </a:lnTo>
                    <a:lnTo>
                      <a:pt x="50" y="142"/>
                    </a:lnTo>
                    <a:lnTo>
                      <a:pt x="57" y="142"/>
                    </a:lnTo>
                    <a:lnTo>
                      <a:pt x="57" y="135"/>
                    </a:lnTo>
                    <a:lnTo>
                      <a:pt x="64" y="135"/>
                    </a:lnTo>
                    <a:lnTo>
                      <a:pt x="64" y="142"/>
                    </a:lnTo>
                    <a:lnTo>
                      <a:pt x="71" y="135"/>
                    </a:lnTo>
                    <a:lnTo>
                      <a:pt x="78" y="135"/>
                    </a:lnTo>
                    <a:lnTo>
                      <a:pt x="78" y="142"/>
                    </a:lnTo>
                    <a:lnTo>
                      <a:pt x="85" y="142"/>
                    </a:lnTo>
                    <a:lnTo>
                      <a:pt x="85" y="135"/>
                    </a:lnTo>
                    <a:lnTo>
                      <a:pt x="92" y="142"/>
                    </a:lnTo>
                    <a:lnTo>
                      <a:pt x="99" y="142"/>
                    </a:lnTo>
                    <a:lnTo>
                      <a:pt x="99" y="135"/>
                    </a:lnTo>
                    <a:lnTo>
                      <a:pt x="106" y="142"/>
                    </a:lnTo>
                    <a:lnTo>
                      <a:pt x="113" y="142"/>
                    </a:lnTo>
                    <a:lnTo>
                      <a:pt x="113" y="135"/>
                    </a:lnTo>
                    <a:lnTo>
                      <a:pt x="121" y="135"/>
                    </a:lnTo>
                    <a:lnTo>
                      <a:pt x="121" y="142"/>
                    </a:lnTo>
                    <a:lnTo>
                      <a:pt x="128" y="135"/>
                    </a:lnTo>
                    <a:lnTo>
                      <a:pt x="135" y="135"/>
                    </a:lnTo>
                    <a:lnTo>
                      <a:pt x="142" y="135"/>
                    </a:lnTo>
                    <a:lnTo>
                      <a:pt x="149" y="135"/>
                    </a:lnTo>
                    <a:lnTo>
                      <a:pt x="156" y="135"/>
                    </a:lnTo>
                    <a:lnTo>
                      <a:pt x="163" y="135"/>
                    </a:lnTo>
                    <a:lnTo>
                      <a:pt x="163" y="127"/>
                    </a:lnTo>
                    <a:lnTo>
                      <a:pt x="170" y="127"/>
                    </a:lnTo>
                    <a:lnTo>
                      <a:pt x="170" y="135"/>
                    </a:lnTo>
                    <a:lnTo>
                      <a:pt x="177" y="135"/>
                    </a:lnTo>
                    <a:lnTo>
                      <a:pt x="184" y="135"/>
                    </a:lnTo>
                    <a:lnTo>
                      <a:pt x="191" y="135"/>
                    </a:lnTo>
                    <a:lnTo>
                      <a:pt x="198" y="135"/>
                    </a:lnTo>
                    <a:lnTo>
                      <a:pt x="206" y="135"/>
                    </a:lnTo>
                    <a:lnTo>
                      <a:pt x="213" y="135"/>
                    </a:lnTo>
                    <a:lnTo>
                      <a:pt x="220" y="135"/>
                    </a:lnTo>
                    <a:lnTo>
                      <a:pt x="227" y="135"/>
                    </a:lnTo>
                    <a:lnTo>
                      <a:pt x="227" y="127"/>
                    </a:lnTo>
                    <a:lnTo>
                      <a:pt x="234" y="127"/>
                    </a:lnTo>
                    <a:lnTo>
                      <a:pt x="234" y="135"/>
                    </a:lnTo>
                    <a:lnTo>
                      <a:pt x="241" y="135"/>
                    </a:lnTo>
                    <a:lnTo>
                      <a:pt x="241" y="127"/>
                    </a:lnTo>
                    <a:lnTo>
                      <a:pt x="248" y="127"/>
                    </a:lnTo>
                    <a:lnTo>
                      <a:pt x="248" y="135"/>
                    </a:lnTo>
                    <a:lnTo>
                      <a:pt x="255" y="127"/>
                    </a:lnTo>
                    <a:lnTo>
                      <a:pt x="262" y="127"/>
                    </a:lnTo>
                    <a:lnTo>
                      <a:pt x="269" y="127"/>
                    </a:lnTo>
                    <a:lnTo>
                      <a:pt x="269" y="120"/>
                    </a:lnTo>
                    <a:lnTo>
                      <a:pt x="276" y="127"/>
                    </a:lnTo>
                    <a:lnTo>
                      <a:pt x="276" y="135"/>
                    </a:lnTo>
                    <a:lnTo>
                      <a:pt x="283" y="135"/>
                    </a:lnTo>
                    <a:lnTo>
                      <a:pt x="283" y="127"/>
                    </a:lnTo>
                    <a:lnTo>
                      <a:pt x="291" y="127"/>
                    </a:lnTo>
                    <a:lnTo>
                      <a:pt x="291" y="135"/>
                    </a:lnTo>
                    <a:lnTo>
                      <a:pt x="298" y="135"/>
                    </a:lnTo>
                    <a:lnTo>
                      <a:pt x="298" y="127"/>
                    </a:lnTo>
                    <a:lnTo>
                      <a:pt x="305" y="127"/>
                    </a:lnTo>
                    <a:lnTo>
                      <a:pt x="312" y="127"/>
                    </a:lnTo>
                    <a:lnTo>
                      <a:pt x="312" y="120"/>
                    </a:lnTo>
                    <a:lnTo>
                      <a:pt x="319" y="120"/>
                    </a:lnTo>
                    <a:lnTo>
                      <a:pt x="319" y="127"/>
                    </a:lnTo>
                    <a:lnTo>
                      <a:pt x="326" y="127"/>
                    </a:lnTo>
                    <a:lnTo>
                      <a:pt x="326" y="120"/>
                    </a:lnTo>
                    <a:lnTo>
                      <a:pt x="333" y="127"/>
                    </a:lnTo>
                    <a:lnTo>
                      <a:pt x="340" y="127"/>
                    </a:lnTo>
                    <a:lnTo>
                      <a:pt x="347" y="127"/>
                    </a:lnTo>
                    <a:lnTo>
                      <a:pt x="354" y="127"/>
                    </a:lnTo>
                    <a:lnTo>
                      <a:pt x="361" y="127"/>
                    </a:lnTo>
                    <a:lnTo>
                      <a:pt x="369" y="127"/>
                    </a:lnTo>
                    <a:lnTo>
                      <a:pt x="369" y="120"/>
                    </a:lnTo>
                    <a:lnTo>
                      <a:pt x="376" y="120"/>
                    </a:lnTo>
                    <a:lnTo>
                      <a:pt x="376" y="127"/>
                    </a:lnTo>
                    <a:lnTo>
                      <a:pt x="383" y="127"/>
                    </a:lnTo>
                    <a:lnTo>
                      <a:pt x="383" y="120"/>
                    </a:lnTo>
                    <a:lnTo>
                      <a:pt x="390" y="120"/>
                    </a:lnTo>
                    <a:lnTo>
                      <a:pt x="397" y="120"/>
                    </a:lnTo>
                    <a:lnTo>
                      <a:pt x="404" y="120"/>
                    </a:lnTo>
                    <a:lnTo>
                      <a:pt x="411" y="120"/>
                    </a:lnTo>
                    <a:lnTo>
                      <a:pt x="411" y="127"/>
                    </a:lnTo>
                    <a:lnTo>
                      <a:pt x="418" y="127"/>
                    </a:lnTo>
                    <a:lnTo>
                      <a:pt x="418" y="120"/>
                    </a:lnTo>
                    <a:lnTo>
                      <a:pt x="425" y="120"/>
                    </a:lnTo>
                    <a:lnTo>
                      <a:pt x="425" y="127"/>
                    </a:lnTo>
                    <a:lnTo>
                      <a:pt x="432" y="120"/>
                    </a:lnTo>
                    <a:lnTo>
                      <a:pt x="439" y="120"/>
                    </a:lnTo>
                    <a:lnTo>
                      <a:pt x="439" y="113"/>
                    </a:lnTo>
                    <a:lnTo>
                      <a:pt x="446" y="120"/>
                    </a:lnTo>
                    <a:lnTo>
                      <a:pt x="454" y="120"/>
                    </a:lnTo>
                    <a:lnTo>
                      <a:pt x="461" y="120"/>
                    </a:lnTo>
                    <a:lnTo>
                      <a:pt x="461" y="127"/>
                    </a:lnTo>
                    <a:lnTo>
                      <a:pt x="468" y="127"/>
                    </a:lnTo>
                    <a:lnTo>
                      <a:pt x="468" y="120"/>
                    </a:lnTo>
                    <a:lnTo>
                      <a:pt x="475" y="120"/>
                    </a:lnTo>
                    <a:lnTo>
                      <a:pt x="475" y="156"/>
                    </a:lnTo>
                    <a:lnTo>
                      <a:pt x="482" y="156"/>
                    </a:lnTo>
                    <a:lnTo>
                      <a:pt x="482" y="184"/>
                    </a:lnTo>
                    <a:lnTo>
                      <a:pt x="489" y="184"/>
                    </a:lnTo>
                    <a:lnTo>
                      <a:pt x="489" y="234"/>
                    </a:lnTo>
                    <a:lnTo>
                      <a:pt x="496" y="241"/>
                    </a:lnTo>
                    <a:lnTo>
                      <a:pt x="496" y="269"/>
                    </a:lnTo>
                    <a:lnTo>
                      <a:pt x="503" y="269"/>
                    </a:lnTo>
                    <a:lnTo>
                      <a:pt x="503" y="283"/>
                    </a:lnTo>
                    <a:lnTo>
                      <a:pt x="510" y="283"/>
                    </a:lnTo>
                    <a:lnTo>
                      <a:pt x="510" y="305"/>
                    </a:lnTo>
                    <a:lnTo>
                      <a:pt x="517" y="305"/>
                    </a:lnTo>
                    <a:lnTo>
                      <a:pt x="517" y="312"/>
                    </a:lnTo>
                    <a:lnTo>
                      <a:pt x="524" y="312"/>
                    </a:lnTo>
                    <a:lnTo>
                      <a:pt x="524" y="326"/>
                    </a:lnTo>
                    <a:lnTo>
                      <a:pt x="532" y="326"/>
                    </a:lnTo>
                    <a:lnTo>
                      <a:pt x="532" y="340"/>
                    </a:lnTo>
                    <a:lnTo>
                      <a:pt x="539" y="340"/>
                    </a:lnTo>
                    <a:lnTo>
                      <a:pt x="539" y="347"/>
                    </a:lnTo>
                    <a:lnTo>
                      <a:pt x="546" y="347"/>
                    </a:lnTo>
                    <a:lnTo>
                      <a:pt x="546" y="376"/>
                    </a:lnTo>
                    <a:lnTo>
                      <a:pt x="553" y="376"/>
                    </a:lnTo>
                    <a:lnTo>
                      <a:pt x="553" y="390"/>
                    </a:lnTo>
                    <a:lnTo>
                      <a:pt x="560" y="397"/>
                    </a:lnTo>
                    <a:lnTo>
                      <a:pt x="560" y="368"/>
                    </a:lnTo>
                    <a:lnTo>
                      <a:pt x="567" y="397"/>
                    </a:lnTo>
                    <a:lnTo>
                      <a:pt x="567" y="411"/>
                    </a:lnTo>
                    <a:lnTo>
                      <a:pt x="574" y="411"/>
                    </a:lnTo>
                    <a:lnTo>
                      <a:pt x="574" y="418"/>
                    </a:lnTo>
                    <a:lnTo>
                      <a:pt x="581" y="418"/>
                    </a:lnTo>
                    <a:lnTo>
                      <a:pt x="581" y="411"/>
                    </a:lnTo>
                    <a:lnTo>
                      <a:pt x="588" y="411"/>
                    </a:lnTo>
                    <a:lnTo>
                      <a:pt x="588" y="418"/>
                    </a:lnTo>
                    <a:lnTo>
                      <a:pt x="595" y="418"/>
                    </a:lnTo>
                    <a:lnTo>
                      <a:pt x="595" y="411"/>
                    </a:lnTo>
                    <a:lnTo>
                      <a:pt x="602" y="411"/>
                    </a:lnTo>
                    <a:lnTo>
                      <a:pt x="602" y="418"/>
                    </a:lnTo>
                    <a:lnTo>
                      <a:pt x="609" y="418"/>
                    </a:lnTo>
                    <a:lnTo>
                      <a:pt x="609" y="347"/>
                    </a:lnTo>
                    <a:lnTo>
                      <a:pt x="617" y="319"/>
                    </a:lnTo>
                    <a:lnTo>
                      <a:pt x="617" y="127"/>
                    </a:lnTo>
                    <a:lnTo>
                      <a:pt x="624" y="127"/>
                    </a:lnTo>
                    <a:lnTo>
                      <a:pt x="624" y="78"/>
                    </a:lnTo>
                    <a:lnTo>
                      <a:pt x="631" y="78"/>
                    </a:lnTo>
                    <a:lnTo>
                      <a:pt x="631" y="42"/>
                    </a:lnTo>
                    <a:lnTo>
                      <a:pt x="638" y="42"/>
                    </a:lnTo>
                    <a:lnTo>
                      <a:pt x="638" y="35"/>
                    </a:lnTo>
                    <a:lnTo>
                      <a:pt x="645" y="35"/>
                    </a:lnTo>
                    <a:lnTo>
                      <a:pt x="645" y="28"/>
                    </a:lnTo>
                    <a:lnTo>
                      <a:pt x="652" y="28"/>
                    </a:lnTo>
                    <a:lnTo>
                      <a:pt x="652" y="21"/>
                    </a:lnTo>
                    <a:lnTo>
                      <a:pt x="659" y="21"/>
                    </a:lnTo>
                    <a:lnTo>
                      <a:pt x="666" y="21"/>
                    </a:lnTo>
                    <a:lnTo>
                      <a:pt x="673" y="21"/>
                    </a:lnTo>
                    <a:lnTo>
                      <a:pt x="673" y="28"/>
                    </a:lnTo>
                    <a:lnTo>
                      <a:pt x="680" y="28"/>
                    </a:lnTo>
                    <a:lnTo>
                      <a:pt x="680" y="21"/>
                    </a:lnTo>
                    <a:lnTo>
                      <a:pt x="687" y="28"/>
                    </a:lnTo>
                    <a:lnTo>
                      <a:pt x="694" y="28"/>
                    </a:lnTo>
                    <a:lnTo>
                      <a:pt x="694" y="35"/>
                    </a:lnTo>
                    <a:lnTo>
                      <a:pt x="702" y="35"/>
                    </a:lnTo>
                    <a:lnTo>
                      <a:pt x="702" y="28"/>
                    </a:lnTo>
                    <a:lnTo>
                      <a:pt x="709" y="35"/>
                    </a:lnTo>
                    <a:lnTo>
                      <a:pt x="709" y="42"/>
                    </a:lnTo>
                    <a:lnTo>
                      <a:pt x="716" y="42"/>
                    </a:lnTo>
                    <a:lnTo>
                      <a:pt x="716" y="35"/>
                    </a:lnTo>
                    <a:lnTo>
                      <a:pt x="723" y="42"/>
                    </a:lnTo>
                    <a:lnTo>
                      <a:pt x="723" y="50"/>
                    </a:lnTo>
                    <a:lnTo>
                      <a:pt x="730" y="50"/>
                    </a:lnTo>
                    <a:lnTo>
                      <a:pt x="737" y="50"/>
                    </a:lnTo>
                    <a:lnTo>
                      <a:pt x="737" y="57"/>
                    </a:lnTo>
                    <a:lnTo>
                      <a:pt x="744" y="57"/>
                    </a:lnTo>
                    <a:lnTo>
                      <a:pt x="744" y="50"/>
                    </a:lnTo>
                    <a:lnTo>
                      <a:pt x="751" y="57"/>
                    </a:lnTo>
                    <a:lnTo>
                      <a:pt x="751" y="64"/>
                    </a:lnTo>
                    <a:lnTo>
                      <a:pt x="758" y="64"/>
                    </a:lnTo>
                    <a:lnTo>
                      <a:pt x="758" y="57"/>
                    </a:lnTo>
                    <a:lnTo>
                      <a:pt x="765" y="64"/>
                    </a:lnTo>
                    <a:lnTo>
                      <a:pt x="772" y="64"/>
                    </a:lnTo>
                    <a:lnTo>
                      <a:pt x="772" y="71"/>
                    </a:lnTo>
                    <a:lnTo>
                      <a:pt x="780" y="71"/>
                    </a:lnTo>
                    <a:lnTo>
                      <a:pt x="780" y="64"/>
                    </a:lnTo>
                    <a:lnTo>
                      <a:pt x="787" y="71"/>
                    </a:lnTo>
                    <a:lnTo>
                      <a:pt x="794" y="71"/>
                    </a:lnTo>
                    <a:lnTo>
                      <a:pt x="794" y="78"/>
                    </a:lnTo>
                    <a:lnTo>
                      <a:pt x="801" y="78"/>
                    </a:lnTo>
                    <a:lnTo>
                      <a:pt x="808" y="78"/>
                    </a:lnTo>
                    <a:lnTo>
                      <a:pt x="815" y="78"/>
                    </a:lnTo>
                    <a:lnTo>
                      <a:pt x="815" y="85"/>
                    </a:lnTo>
                    <a:lnTo>
                      <a:pt x="822" y="85"/>
                    </a:lnTo>
                    <a:lnTo>
                      <a:pt x="822" y="78"/>
                    </a:lnTo>
                    <a:lnTo>
                      <a:pt x="829" y="85"/>
                    </a:lnTo>
                    <a:lnTo>
                      <a:pt x="836" y="85"/>
                    </a:lnTo>
                    <a:lnTo>
                      <a:pt x="836" y="92"/>
                    </a:lnTo>
                    <a:lnTo>
                      <a:pt x="843" y="92"/>
                    </a:lnTo>
                    <a:lnTo>
                      <a:pt x="843" y="85"/>
                    </a:lnTo>
                    <a:lnTo>
                      <a:pt x="850" y="92"/>
                    </a:lnTo>
                    <a:lnTo>
                      <a:pt x="857" y="92"/>
                    </a:lnTo>
                    <a:lnTo>
                      <a:pt x="857" y="99"/>
                    </a:lnTo>
                    <a:lnTo>
                      <a:pt x="865" y="99"/>
                    </a:lnTo>
                    <a:lnTo>
                      <a:pt x="865" y="92"/>
                    </a:lnTo>
                    <a:lnTo>
                      <a:pt x="872" y="99"/>
                    </a:lnTo>
                    <a:lnTo>
                      <a:pt x="879" y="99"/>
                    </a:lnTo>
                    <a:lnTo>
                      <a:pt x="879" y="106"/>
                    </a:lnTo>
                    <a:lnTo>
                      <a:pt x="886" y="106"/>
                    </a:lnTo>
                    <a:lnTo>
                      <a:pt x="886" y="99"/>
                    </a:lnTo>
                    <a:lnTo>
                      <a:pt x="893" y="99"/>
                    </a:lnTo>
                    <a:lnTo>
                      <a:pt x="893" y="106"/>
                    </a:lnTo>
                    <a:lnTo>
                      <a:pt x="900" y="106"/>
                    </a:lnTo>
                    <a:lnTo>
                      <a:pt x="900" y="99"/>
                    </a:lnTo>
                    <a:lnTo>
                      <a:pt x="907" y="99"/>
                    </a:lnTo>
                    <a:lnTo>
                      <a:pt x="907" y="106"/>
                    </a:lnTo>
                    <a:lnTo>
                      <a:pt x="914" y="106"/>
                    </a:lnTo>
                    <a:lnTo>
                      <a:pt x="921" y="106"/>
                    </a:lnTo>
                    <a:lnTo>
                      <a:pt x="928" y="106"/>
                    </a:lnTo>
                    <a:lnTo>
                      <a:pt x="928" y="113"/>
                    </a:lnTo>
                    <a:lnTo>
                      <a:pt x="935" y="106"/>
                    </a:lnTo>
                    <a:lnTo>
                      <a:pt x="943" y="106"/>
                    </a:lnTo>
                    <a:lnTo>
                      <a:pt x="950" y="106"/>
                    </a:lnTo>
                    <a:lnTo>
                      <a:pt x="957" y="106"/>
                    </a:lnTo>
                    <a:lnTo>
                      <a:pt x="964" y="106"/>
                    </a:lnTo>
                    <a:lnTo>
                      <a:pt x="971" y="106"/>
                    </a:lnTo>
                    <a:lnTo>
                      <a:pt x="978" y="106"/>
                    </a:lnTo>
                    <a:lnTo>
                      <a:pt x="985" y="106"/>
                    </a:lnTo>
                    <a:lnTo>
                      <a:pt x="985" y="99"/>
                    </a:lnTo>
                    <a:lnTo>
                      <a:pt x="992" y="106"/>
                    </a:lnTo>
                    <a:lnTo>
                      <a:pt x="999" y="106"/>
                    </a:lnTo>
                    <a:lnTo>
                      <a:pt x="1006" y="106"/>
                    </a:lnTo>
                    <a:lnTo>
                      <a:pt x="1006" y="99"/>
                    </a:lnTo>
                    <a:lnTo>
                      <a:pt x="1013" y="106"/>
                    </a:lnTo>
                    <a:lnTo>
                      <a:pt x="1020" y="106"/>
                    </a:lnTo>
                    <a:lnTo>
                      <a:pt x="1020" y="99"/>
                    </a:lnTo>
                    <a:lnTo>
                      <a:pt x="1028" y="106"/>
                    </a:lnTo>
                    <a:lnTo>
                      <a:pt x="1035" y="106"/>
                    </a:lnTo>
                    <a:lnTo>
                      <a:pt x="1042" y="106"/>
                    </a:lnTo>
                    <a:lnTo>
                      <a:pt x="1049" y="106"/>
                    </a:lnTo>
                    <a:lnTo>
                      <a:pt x="1056" y="106"/>
                    </a:lnTo>
                    <a:lnTo>
                      <a:pt x="1063" y="106"/>
                    </a:lnTo>
                    <a:lnTo>
                      <a:pt x="1070" y="106"/>
                    </a:lnTo>
                    <a:lnTo>
                      <a:pt x="1077" y="106"/>
                    </a:lnTo>
                    <a:lnTo>
                      <a:pt x="1077" y="99"/>
                    </a:lnTo>
                    <a:lnTo>
                      <a:pt x="1084" y="106"/>
                    </a:lnTo>
                    <a:lnTo>
                      <a:pt x="1091" y="106"/>
                    </a:lnTo>
                    <a:lnTo>
                      <a:pt x="1098" y="106"/>
                    </a:lnTo>
                    <a:lnTo>
                      <a:pt x="1105" y="106"/>
                    </a:lnTo>
                    <a:lnTo>
                      <a:pt x="1105" y="113"/>
                    </a:lnTo>
                    <a:lnTo>
                      <a:pt x="1113" y="113"/>
                    </a:lnTo>
                    <a:lnTo>
                      <a:pt x="1113" y="106"/>
                    </a:lnTo>
                    <a:lnTo>
                      <a:pt x="1120" y="106"/>
                    </a:lnTo>
                    <a:lnTo>
                      <a:pt x="1120" y="113"/>
                    </a:lnTo>
                    <a:lnTo>
                      <a:pt x="1127" y="113"/>
                    </a:lnTo>
                    <a:lnTo>
                      <a:pt x="1127" y="106"/>
                    </a:lnTo>
                    <a:lnTo>
                      <a:pt x="1134" y="106"/>
                    </a:lnTo>
                    <a:lnTo>
                      <a:pt x="1134" y="113"/>
                    </a:lnTo>
                    <a:lnTo>
                      <a:pt x="1141" y="113"/>
                    </a:lnTo>
                    <a:lnTo>
                      <a:pt x="1141" y="106"/>
                    </a:lnTo>
                    <a:lnTo>
                      <a:pt x="1148" y="106"/>
                    </a:lnTo>
                    <a:lnTo>
                      <a:pt x="1148" y="113"/>
                    </a:lnTo>
                    <a:lnTo>
                      <a:pt x="1155" y="113"/>
                    </a:lnTo>
                    <a:lnTo>
                      <a:pt x="1155" y="106"/>
                    </a:lnTo>
                    <a:lnTo>
                      <a:pt x="1162" y="106"/>
                    </a:lnTo>
                    <a:lnTo>
                      <a:pt x="1162" y="113"/>
                    </a:lnTo>
                    <a:lnTo>
                      <a:pt x="1169" y="106"/>
                    </a:lnTo>
                    <a:lnTo>
                      <a:pt x="1176" y="106"/>
                    </a:lnTo>
                    <a:lnTo>
                      <a:pt x="1183" y="106"/>
                    </a:lnTo>
                    <a:lnTo>
                      <a:pt x="1183" y="99"/>
                    </a:lnTo>
                    <a:lnTo>
                      <a:pt x="1191" y="99"/>
                    </a:lnTo>
                    <a:lnTo>
                      <a:pt x="1191" y="106"/>
                    </a:lnTo>
                    <a:lnTo>
                      <a:pt x="1198" y="106"/>
                    </a:lnTo>
                    <a:lnTo>
                      <a:pt x="1198" y="113"/>
                    </a:lnTo>
                    <a:lnTo>
                      <a:pt x="1205" y="113"/>
                    </a:lnTo>
                    <a:lnTo>
                      <a:pt x="1205" y="106"/>
                    </a:lnTo>
                    <a:lnTo>
                      <a:pt x="1212" y="106"/>
                    </a:lnTo>
                    <a:lnTo>
                      <a:pt x="1212" y="113"/>
                    </a:lnTo>
                    <a:lnTo>
                      <a:pt x="1219" y="113"/>
                    </a:lnTo>
                    <a:lnTo>
                      <a:pt x="1219" y="106"/>
                    </a:lnTo>
                    <a:lnTo>
                      <a:pt x="1226" y="106"/>
                    </a:lnTo>
                    <a:lnTo>
                      <a:pt x="1226" y="113"/>
                    </a:lnTo>
                    <a:lnTo>
                      <a:pt x="1233" y="106"/>
                    </a:lnTo>
                    <a:lnTo>
                      <a:pt x="1240" y="106"/>
                    </a:lnTo>
                    <a:lnTo>
                      <a:pt x="1247" y="106"/>
                    </a:lnTo>
                    <a:lnTo>
                      <a:pt x="1247" y="99"/>
                    </a:lnTo>
                    <a:lnTo>
                      <a:pt x="1254" y="99"/>
                    </a:lnTo>
                    <a:lnTo>
                      <a:pt x="1254" y="106"/>
                    </a:lnTo>
                    <a:lnTo>
                      <a:pt x="1261" y="106"/>
                    </a:lnTo>
                    <a:lnTo>
                      <a:pt x="1261" y="99"/>
                    </a:lnTo>
                    <a:lnTo>
                      <a:pt x="1268" y="106"/>
                    </a:lnTo>
                    <a:lnTo>
                      <a:pt x="1276" y="106"/>
                    </a:lnTo>
                    <a:lnTo>
                      <a:pt x="1283" y="106"/>
                    </a:lnTo>
                    <a:lnTo>
                      <a:pt x="1283" y="113"/>
                    </a:lnTo>
                    <a:lnTo>
                      <a:pt x="1290" y="106"/>
                    </a:lnTo>
                    <a:lnTo>
                      <a:pt x="1297" y="106"/>
                    </a:lnTo>
                    <a:lnTo>
                      <a:pt x="1297" y="113"/>
                    </a:lnTo>
                    <a:lnTo>
                      <a:pt x="1304" y="113"/>
                    </a:lnTo>
                    <a:lnTo>
                      <a:pt x="1304" y="106"/>
                    </a:lnTo>
                    <a:lnTo>
                      <a:pt x="1311" y="106"/>
                    </a:lnTo>
                    <a:lnTo>
                      <a:pt x="1311" y="113"/>
                    </a:lnTo>
                    <a:lnTo>
                      <a:pt x="1318" y="106"/>
                    </a:lnTo>
                    <a:lnTo>
                      <a:pt x="1325" y="106"/>
                    </a:lnTo>
                    <a:lnTo>
                      <a:pt x="1332" y="106"/>
                    </a:lnTo>
                    <a:lnTo>
                      <a:pt x="1332" y="99"/>
                    </a:lnTo>
                    <a:lnTo>
                      <a:pt x="1339" y="99"/>
                    </a:lnTo>
                    <a:lnTo>
                      <a:pt x="1339" y="106"/>
                    </a:lnTo>
                    <a:lnTo>
                      <a:pt x="1346" y="106"/>
                    </a:lnTo>
                    <a:lnTo>
                      <a:pt x="1346" y="99"/>
                    </a:lnTo>
                    <a:lnTo>
                      <a:pt x="1354" y="99"/>
                    </a:lnTo>
                    <a:lnTo>
                      <a:pt x="1354" y="106"/>
                    </a:lnTo>
                    <a:lnTo>
                      <a:pt x="1361" y="106"/>
                    </a:lnTo>
                    <a:lnTo>
                      <a:pt x="1368" y="106"/>
                    </a:lnTo>
                    <a:lnTo>
                      <a:pt x="1375" y="106"/>
                    </a:lnTo>
                    <a:lnTo>
                      <a:pt x="1382" y="106"/>
                    </a:lnTo>
                    <a:lnTo>
                      <a:pt x="1382" y="99"/>
                    </a:lnTo>
                    <a:lnTo>
                      <a:pt x="1389" y="99"/>
                    </a:lnTo>
                    <a:lnTo>
                      <a:pt x="1389" y="106"/>
                    </a:lnTo>
                    <a:lnTo>
                      <a:pt x="1396" y="106"/>
                    </a:lnTo>
                    <a:lnTo>
                      <a:pt x="1396" y="99"/>
                    </a:lnTo>
                    <a:lnTo>
                      <a:pt x="1403" y="99"/>
                    </a:lnTo>
                    <a:lnTo>
                      <a:pt x="1403" y="106"/>
                    </a:lnTo>
                    <a:lnTo>
                      <a:pt x="1410" y="106"/>
                    </a:lnTo>
                    <a:lnTo>
                      <a:pt x="1410" y="99"/>
                    </a:lnTo>
                    <a:lnTo>
                      <a:pt x="1417" y="99"/>
                    </a:lnTo>
                    <a:lnTo>
                      <a:pt x="1417" y="106"/>
                    </a:lnTo>
                    <a:lnTo>
                      <a:pt x="1424" y="106"/>
                    </a:lnTo>
                    <a:lnTo>
                      <a:pt x="1431" y="106"/>
                    </a:lnTo>
                    <a:lnTo>
                      <a:pt x="1431" y="99"/>
                    </a:lnTo>
                    <a:lnTo>
                      <a:pt x="1439" y="99"/>
                    </a:lnTo>
                    <a:lnTo>
                      <a:pt x="1446" y="99"/>
                    </a:lnTo>
                    <a:lnTo>
                      <a:pt x="1446" y="106"/>
                    </a:lnTo>
                    <a:lnTo>
                      <a:pt x="1453" y="106"/>
                    </a:lnTo>
                    <a:lnTo>
                      <a:pt x="1453" y="99"/>
                    </a:lnTo>
                    <a:lnTo>
                      <a:pt x="1460" y="106"/>
                    </a:lnTo>
                    <a:lnTo>
                      <a:pt x="1467" y="106"/>
                    </a:lnTo>
                    <a:lnTo>
                      <a:pt x="1467" y="99"/>
                    </a:lnTo>
                    <a:lnTo>
                      <a:pt x="1474" y="99"/>
                    </a:lnTo>
                    <a:lnTo>
                      <a:pt x="1481" y="99"/>
                    </a:lnTo>
                    <a:lnTo>
                      <a:pt x="1488" y="99"/>
                    </a:lnTo>
                    <a:lnTo>
                      <a:pt x="1488" y="106"/>
                    </a:lnTo>
                    <a:lnTo>
                      <a:pt x="1495" y="106"/>
                    </a:lnTo>
                    <a:lnTo>
                      <a:pt x="1495" y="99"/>
                    </a:lnTo>
                    <a:lnTo>
                      <a:pt x="1502" y="99"/>
                    </a:lnTo>
                    <a:lnTo>
                      <a:pt x="1502" y="106"/>
                    </a:lnTo>
                    <a:lnTo>
                      <a:pt x="1509" y="106"/>
                    </a:lnTo>
                    <a:lnTo>
                      <a:pt x="1509" y="99"/>
                    </a:lnTo>
                    <a:lnTo>
                      <a:pt x="1516" y="99"/>
                    </a:lnTo>
                    <a:lnTo>
                      <a:pt x="1524" y="99"/>
                    </a:lnTo>
                    <a:lnTo>
                      <a:pt x="1524" y="106"/>
                    </a:lnTo>
                    <a:lnTo>
                      <a:pt x="1531" y="106"/>
                    </a:lnTo>
                    <a:lnTo>
                      <a:pt x="1531" y="99"/>
                    </a:lnTo>
                    <a:lnTo>
                      <a:pt x="1538" y="99"/>
                    </a:lnTo>
                    <a:lnTo>
                      <a:pt x="1538" y="106"/>
                    </a:lnTo>
                    <a:lnTo>
                      <a:pt x="1545" y="99"/>
                    </a:lnTo>
                    <a:lnTo>
                      <a:pt x="1552" y="99"/>
                    </a:lnTo>
                    <a:lnTo>
                      <a:pt x="1559" y="99"/>
                    </a:lnTo>
                    <a:lnTo>
                      <a:pt x="1559" y="106"/>
                    </a:lnTo>
                    <a:lnTo>
                      <a:pt x="1566" y="106"/>
                    </a:lnTo>
                    <a:lnTo>
                      <a:pt x="1566" y="99"/>
                    </a:lnTo>
                    <a:lnTo>
                      <a:pt x="1573" y="99"/>
                    </a:lnTo>
                    <a:lnTo>
                      <a:pt x="1573" y="106"/>
                    </a:lnTo>
                    <a:lnTo>
                      <a:pt x="1580" y="99"/>
                    </a:lnTo>
                    <a:lnTo>
                      <a:pt x="1587" y="99"/>
                    </a:lnTo>
                    <a:lnTo>
                      <a:pt x="1587" y="106"/>
                    </a:lnTo>
                    <a:lnTo>
                      <a:pt x="1594" y="106"/>
                    </a:lnTo>
                    <a:lnTo>
                      <a:pt x="1594" y="99"/>
                    </a:lnTo>
                    <a:lnTo>
                      <a:pt x="1602" y="99"/>
                    </a:lnTo>
                    <a:lnTo>
                      <a:pt x="1602" y="106"/>
                    </a:lnTo>
                    <a:lnTo>
                      <a:pt x="1609" y="99"/>
                    </a:lnTo>
                    <a:lnTo>
                      <a:pt x="1616" y="99"/>
                    </a:lnTo>
                    <a:lnTo>
                      <a:pt x="1616" y="106"/>
                    </a:lnTo>
                    <a:lnTo>
                      <a:pt x="1623" y="106"/>
                    </a:lnTo>
                    <a:lnTo>
                      <a:pt x="1623" y="99"/>
                    </a:lnTo>
                    <a:lnTo>
                      <a:pt x="1630" y="99"/>
                    </a:lnTo>
                    <a:lnTo>
                      <a:pt x="1637" y="99"/>
                    </a:lnTo>
                    <a:lnTo>
                      <a:pt x="1637" y="0"/>
                    </a:lnTo>
                    <a:lnTo>
                      <a:pt x="1644" y="99"/>
                    </a:lnTo>
                    <a:lnTo>
                      <a:pt x="1644" y="106"/>
                    </a:lnTo>
                    <a:lnTo>
                      <a:pt x="1651" y="106"/>
                    </a:lnTo>
                    <a:lnTo>
                      <a:pt x="1651" y="99"/>
                    </a:lnTo>
                    <a:lnTo>
                      <a:pt x="1658" y="99"/>
                    </a:lnTo>
                    <a:lnTo>
                      <a:pt x="1658" y="106"/>
                    </a:lnTo>
                    <a:lnTo>
                      <a:pt x="1665" y="106"/>
                    </a:lnTo>
                    <a:lnTo>
                      <a:pt x="1665" y="99"/>
                    </a:lnTo>
                    <a:lnTo>
                      <a:pt x="1672" y="99"/>
                    </a:lnTo>
                    <a:lnTo>
                      <a:pt x="1672" y="106"/>
                    </a:lnTo>
                    <a:lnTo>
                      <a:pt x="1679" y="106"/>
                    </a:lnTo>
                    <a:lnTo>
                      <a:pt x="1679" y="99"/>
                    </a:lnTo>
                    <a:lnTo>
                      <a:pt x="1687" y="99"/>
                    </a:lnTo>
                    <a:lnTo>
                      <a:pt x="1687" y="106"/>
                    </a:lnTo>
                    <a:lnTo>
                      <a:pt x="1694" y="106"/>
                    </a:lnTo>
                    <a:lnTo>
                      <a:pt x="1694" y="99"/>
                    </a:lnTo>
                    <a:lnTo>
                      <a:pt x="1701" y="99"/>
                    </a:lnTo>
                    <a:lnTo>
                      <a:pt x="1708" y="99"/>
                    </a:lnTo>
                    <a:lnTo>
                      <a:pt x="1708" y="106"/>
                    </a:lnTo>
                    <a:lnTo>
                      <a:pt x="1715" y="106"/>
                    </a:lnTo>
                    <a:lnTo>
                      <a:pt x="1715" y="99"/>
                    </a:lnTo>
                    <a:lnTo>
                      <a:pt x="1722" y="99"/>
                    </a:lnTo>
                    <a:lnTo>
                      <a:pt x="1722" y="106"/>
                    </a:lnTo>
                    <a:lnTo>
                      <a:pt x="1729" y="106"/>
                    </a:lnTo>
                    <a:lnTo>
                      <a:pt x="1729" y="99"/>
                    </a:lnTo>
                    <a:lnTo>
                      <a:pt x="1736" y="99"/>
                    </a:lnTo>
                    <a:lnTo>
                      <a:pt x="1736" y="106"/>
                    </a:lnTo>
                    <a:lnTo>
                      <a:pt x="1743" y="106"/>
                    </a:lnTo>
                    <a:lnTo>
                      <a:pt x="1743" y="99"/>
                    </a:lnTo>
                    <a:lnTo>
                      <a:pt x="1750" y="99"/>
                    </a:lnTo>
                    <a:lnTo>
                      <a:pt x="1750" y="106"/>
                    </a:lnTo>
                    <a:lnTo>
                      <a:pt x="1757" y="99"/>
                    </a:lnTo>
                    <a:lnTo>
                      <a:pt x="1765" y="99"/>
                    </a:lnTo>
                    <a:lnTo>
                      <a:pt x="1765" y="106"/>
                    </a:lnTo>
                    <a:lnTo>
                      <a:pt x="1772" y="106"/>
                    </a:lnTo>
                    <a:lnTo>
                      <a:pt x="1779" y="106"/>
                    </a:lnTo>
                    <a:lnTo>
                      <a:pt x="1779" y="99"/>
                    </a:lnTo>
                    <a:lnTo>
                      <a:pt x="1786" y="99"/>
                    </a:lnTo>
                    <a:lnTo>
                      <a:pt x="1786" y="106"/>
                    </a:lnTo>
                    <a:lnTo>
                      <a:pt x="1793" y="106"/>
                    </a:lnTo>
                    <a:lnTo>
                      <a:pt x="1793" y="99"/>
                    </a:lnTo>
                    <a:lnTo>
                      <a:pt x="1800" y="106"/>
                    </a:lnTo>
                    <a:lnTo>
                      <a:pt x="1800" y="127"/>
                    </a:lnTo>
                    <a:lnTo>
                      <a:pt x="1807" y="127"/>
                    </a:lnTo>
                    <a:lnTo>
                      <a:pt x="1814" y="127"/>
                    </a:lnTo>
                    <a:lnTo>
                      <a:pt x="1814" y="120"/>
                    </a:lnTo>
                    <a:lnTo>
                      <a:pt x="1821" y="120"/>
                    </a:lnTo>
                    <a:lnTo>
                      <a:pt x="1821" y="113"/>
                    </a:lnTo>
                    <a:lnTo>
                      <a:pt x="1828" y="113"/>
                    </a:lnTo>
                    <a:lnTo>
                      <a:pt x="1835" y="113"/>
                    </a:lnTo>
                    <a:lnTo>
                      <a:pt x="1835" y="120"/>
                    </a:lnTo>
                    <a:lnTo>
                      <a:pt x="1842" y="113"/>
                    </a:lnTo>
                    <a:lnTo>
                      <a:pt x="1850" y="113"/>
                    </a:lnTo>
                    <a:lnTo>
                      <a:pt x="1850" y="106"/>
                    </a:lnTo>
                    <a:lnTo>
                      <a:pt x="1857" y="106"/>
                    </a:lnTo>
                    <a:lnTo>
                      <a:pt x="1857" y="113"/>
                    </a:lnTo>
                    <a:lnTo>
                      <a:pt x="1864" y="113"/>
                    </a:lnTo>
                    <a:lnTo>
                      <a:pt x="1864" y="106"/>
                    </a:lnTo>
                    <a:lnTo>
                      <a:pt x="1871" y="106"/>
                    </a:lnTo>
                    <a:lnTo>
                      <a:pt x="1871" y="113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Freeform 72"/>
              <p:cNvSpPr/>
              <p:nvPr/>
            </p:nvSpPr>
            <p:spPr>
              <a:xfrm>
                <a:off x="3858480" y="4444920"/>
                <a:ext cx="563400" cy="44280"/>
              </a:xfrm>
              <a:custGeom>
                <a:avLst/>
                <a:gdLst/>
                <a:ahLst/>
                <a:rect l="l" t="t" r="r" b="b"/>
                <a:pathLst>
                  <a:path w="1878" h="28">
                    <a:moveTo>
                      <a:pt x="0" y="14"/>
                    </a:moveTo>
                    <a:lnTo>
                      <a:pt x="7" y="7"/>
                    </a:lnTo>
                    <a:lnTo>
                      <a:pt x="14" y="7"/>
                    </a:lnTo>
                    <a:lnTo>
                      <a:pt x="14" y="14"/>
                    </a:lnTo>
                    <a:lnTo>
                      <a:pt x="21" y="14"/>
                    </a:lnTo>
                    <a:lnTo>
                      <a:pt x="21" y="7"/>
                    </a:lnTo>
                    <a:lnTo>
                      <a:pt x="28" y="7"/>
                    </a:lnTo>
                    <a:lnTo>
                      <a:pt x="28" y="14"/>
                    </a:lnTo>
                    <a:lnTo>
                      <a:pt x="35" y="14"/>
                    </a:lnTo>
                    <a:lnTo>
                      <a:pt x="35" y="7"/>
                    </a:lnTo>
                    <a:lnTo>
                      <a:pt x="42" y="7"/>
                    </a:lnTo>
                    <a:lnTo>
                      <a:pt x="42" y="14"/>
                    </a:lnTo>
                    <a:lnTo>
                      <a:pt x="49" y="14"/>
                    </a:lnTo>
                    <a:lnTo>
                      <a:pt x="49" y="7"/>
                    </a:lnTo>
                    <a:lnTo>
                      <a:pt x="57" y="7"/>
                    </a:lnTo>
                    <a:lnTo>
                      <a:pt x="57" y="14"/>
                    </a:lnTo>
                    <a:lnTo>
                      <a:pt x="64" y="7"/>
                    </a:lnTo>
                    <a:lnTo>
                      <a:pt x="71" y="7"/>
                    </a:lnTo>
                    <a:lnTo>
                      <a:pt x="71" y="14"/>
                    </a:lnTo>
                    <a:lnTo>
                      <a:pt x="78" y="14"/>
                    </a:lnTo>
                    <a:lnTo>
                      <a:pt x="78" y="7"/>
                    </a:lnTo>
                    <a:lnTo>
                      <a:pt x="85" y="7"/>
                    </a:lnTo>
                    <a:lnTo>
                      <a:pt x="85" y="14"/>
                    </a:lnTo>
                    <a:lnTo>
                      <a:pt x="92" y="7"/>
                    </a:lnTo>
                    <a:lnTo>
                      <a:pt x="99" y="7"/>
                    </a:lnTo>
                    <a:lnTo>
                      <a:pt x="106" y="7"/>
                    </a:lnTo>
                    <a:lnTo>
                      <a:pt x="106" y="0"/>
                    </a:lnTo>
                    <a:lnTo>
                      <a:pt x="113" y="7"/>
                    </a:lnTo>
                    <a:lnTo>
                      <a:pt x="113" y="14"/>
                    </a:lnTo>
                    <a:lnTo>
                      <a:pt x="120" y="7"/>
                    </a:lnTo>
                    <a:lnTo>
                      <a:pt x="127" y="7"/>
                    </a:lnTo>
                    <a:lnTo>
                      <a:pt x="127" y="14"/>
                    </a:lnTo>
                    <a:lnTo>
                      <a:pt x="134" y="14"/>
                    </a:lnTo>
                    <a:lnTo>
                      <a:pt x="142" y="14"/>
                    </a:lnTo>
                    <a:lnTo>
                      <a:pt x="142" y="7"/>
                    </a:lnTo>
                    <a:lnTo>
                      <a:pt x="149" y="7"/>
                    </a:lnTo>
                    <a:lnTo>
                      <a:pt x="149" y="14"/>
                    </a:lnTo>
                    <a:lnTo>
                      <a:pt x="156" y="7"/>
                    </a:lnTo>
                    <a:lnTo>
                      <a:pt x="163" y="7"/>
                    </a:lnTo>
                    <a:lnTo>
                      <a:pt x="170" y="7"/>
                    </a:lnTo>
                    <a:lnTo>
                      <a:pt x="177" y="7"/>
                    </a:lnTo>
                    <a:lnTo>
                      <a:pt x="184" y="7"/>
                    </a:lnTo>
                    <a:lnTo>
                      <a:pt x="191" y="7"/>
                    </a:lnTo>
                    <a:lnTo>
                      <a:pt x="191" y="14"/>
                    </a:lnTo>
                    <a:lnTo>
                      <a:pt x="198" y="14"/>
                    </a:lnTo>
                    <a:lnTo>
                      <a:pt x="198" y="7"/>
                    </a:lnTo>
                    <a:lnTo>
                      <a:pt x="205" y="7"/>
                    </a:lnTo>
                    <a:lnTo>
                      <a:pt x="205" y="14"/>
                    </a:lnTo>
                    <a:lnTo>
                      <a:pt x="212" y="14"/>
                    </a:lnTo>
                    <a:lnTo>
                      <a:pt x="212" y="7"/>
                    </a:lnTo>
                    <a:lnTo>
                      <a:pt x="219" y="7"/>
                    </a:lnTo>
                    <a:lnTo>
                      <a:pt x="219" y="14"/>
                    </a:lnTo>
                    <a:lnTo>
                      <a:pt x="227" y="14"/>
                    </a:lnTo>
                    <a:lnTo>
                      <a:pt x="227" y="7"/>
                    </a:lnTo>
                    <a:lnTo>
                      <a:pt x="234" y="7"/>
                    </a:lnTo>
                    <a:lnTo>
                      <a:pt x="234" y="14"/>
                    </a:lnTo>
                    <a:lnTo>
                      <a:pt x="241" y="14"/>
                    </a:lnTo>
                    <a:lnTo>
                      <a:pt x="241" y="7"/>
                    </a:lnTo>
                    <a:lnTo>
                      <a:pt x="248" y="7"/>
                    </a:lnTo>
                    <a:lnTo>
                      <a:pt x="248" y="14"/>
                    </a:lnTo>
                    <a:lnTo>
                      <a:pt x="255" y="14"/>
                    </a:lnTo>
                    <a:lnTo>
                      <a:pt x="255" y="7"/>
                    </a:lnTo>
                    <a:lnTo>
                      <a:pt x="262" y="7"/>
                    </a:lnTo>
                    <a:lnTo>
                      <a:pt x="269" y="7"/>
                    </a:lnTo>
                    <a:lnTo>
                      <a:pt x="269" y="14"/>
                    </a:lnTo>
                    <a:lnTo>
                      <a:pt x="276" y="14"/>
                    </a:lnTo>
                    <a:lnTo>
                      <a:pt x="276" y="7"/>
                    </a:lnTo>
                    <a:lnTo>
                      <a:pt x="283" y="7"/>
                    </a:lnTo>
                    <a:lnTo>
                      <a:pt x="283" y="14"/>
                    </a:lnTo>
                    <a:lnTo>
                      <a:pt x="290" y="7"/>
                    </a:lnTo>
                    <a:lnTo>
                      <a:pt x="297" y="7"/>
                    </a:lnTo>
                    <a:lnTo>
                      <a:pt x="305" y="7"/>
                    </a:lnTo>
                    <a:lnTo>
                      <a:pt x="312" y="7"/>
                    </a:lnTo>
                    <a:lnTo>
                      <a:pt x="312" y="14"/>
                    </a:lnTo>
                    <a:lnTo>
                      <a:pt x="319" y="14"/>
                    </a:lnTo>
                    <a:lnTo>
                      <a:pt x="319" y="7"/>
                    </a:lnTo>
                    <a:lnTo>
                      <a:pt x="326" y="7"/>
                    </a:lnTo>
                    <a:lnTo>
                      <a:pt x="333" y="7"/>
                    </a:lnTo>
                    <a:lnTo>
                      <a:pt x="340" y="7"/>
                    </a:lnTo>
                    <a:lnTo>
                      <a:pt x="347" y="7"/>
                    </a:lnTo>
                    <a:lnTo>
                      <a:pt x="354" y="7"/>
                    </a:lnTo>
                    <a:lnTo>
                      <a:pt x="361" y="7"/>
                    </a:lnTo>
                    <a:lnTo>
                      <a:pt x="361" y="0"/>
                    </a:lnTo>
                    <a:lnTo>
                      <a:pt x="368" y="7"/>
                    </a:lnTo>
                    <a:lnTo>
                      <a:pt x="375" y="7"/>
                    </a:lnTo>
                    <a:lnTo>
                      <a:pt x="382" y="7"/>
                    </a:lnTo>
                    <a:lnTo>
                      <a:pt x="382" y="14"/>
                    </a:lnTo>
                    <a:lnTo>
                      <a:pt x="390" y="14"/>
                    </a:lnTo>
                    <a:lnTo>
                      <a:pt x="390" y="7"/>
                    </a:lnTo>
                    <a:lnTo>
                      <a:pt x="397" y="7"/>
                    </a:lnTo>
                    <a:lnTo>
                      <a:pt x="397" y="14"/>
                    </a:lnTo>
                    <a:lnTo>
                      <a:pt x="404" y="14"/>
                    </a:lnTo>
                    <a:lnTo>
                      <a:pt x="404" y="7"/>
                    </a:lnTo>
                    <a:lnTo>
                      <a:pt x="411" y="7"/>
                    </a:lnTo>
                    <a:lnTo>
                      <a:pt x="411" y="14"/>
                    </a:lnTo>
                    <a:lnTo>
                      <a:pt x="418" y="14"/>
                    </a:lnTo>
                    <a:lnTo>
                      <a:pt x="418" y="7"/>
                    </a:lnTo>
                    <a:lnTo>
                      <a:pt x="425" y="7"/>
                    </a:lnTo>
                    <a:lnTo>
                      <a:pt x="425" y="14"/>
                    </a:lnTo>
                    <a:lnTo>
                      <a:pt x="432" y="7"/>
                    </a:lnTo>
                    <a:lnTo>
                      <a:pt x="439" y="7"/>
                    </a:lnTo>
                    <a:lnTo>
                      <a:pt x="439" y="14"/>
                    </a:lnTo>
                    <a:lnTo>
                      <a:pt x="446" y="14"/>
                    </a:lnTo>
                    <a:lnTo>
                      <a:pt x="446" y="7"/>
                    </a:lnTo>
                    <a:lnTo>
                      <a:pt x="453" y="7"/>
                    </a:lnTo>
                    <a:lnTo>
                      <a:pt x="453" y="14"/>
                    </a:lnTo>
                    <a:lnTo>
                      <a:pt x="460" y="7"/>
                    </a:lnTo>
                    <a:lnTo>
                      <a:pt x="468" y="7"/>
                    </a:lnTo>
                    <a:lnTo>
                      <a:pt x="475" y="7"/>
                    </a:lnTo>
                    <a:lnTo>
                      <a:pt x="475" y="14"/>
                    </a:lnTo>
                    <a:lnTo>
                      <a:pt x="482" y="14"/>
                    </a:lnTo>
                    <a:lnTo>
                      <a:pt x="482" y="7"/>
                    </a:lnTo>
                    <a:lnTo>
                      <a:pt x="489" y="7"/>
                    </a:lnTo>
                    <a:lnTo>
                      <a:pt x="489" y="14"/>
                    </a:lnTo>
                    <a:lnTo>
                      <a:pt x="496" y="7"/>
                    </a:lnTo>
                    <a:lnTo>
                      <a:pt x="503" y="7"/>
                    </a:lnTo>
                    <a:lnTo>
                      <a:pt x="510" y="7"/>
                    </a:lnTo>
                    <a:lnTo>
                      <a:pt x="510" y="14"/>
                    </a:lnTo>
                    <a:lnTo>
                      <a:pt x="517" y="14"/>
                    </a:lnTo>
                    <a:lnTo>
                      <a:pt x="517" y="7"/>
                    </a:lnTo>
                    <a:lnTo>
                      <a:pt x="524" y="7"/>
                    </a:lnTo>
                    <a:lnTo>
                      <a:pt x="524" y="14"/>
                    </a:lnTo>
                    <a:lnTo>
                      <a:pt x="531" y="14"/>
                    </a:lnTo>
                    <a:lnTo>
                      <a:pt x="531" y="7"/>
                    </a:lnTo>
                    <a:lnTo>
                      <a:pt x="538" y="7"/>
                    </a:lnTo>
                    <a:lnTo>
                      <a:pt x="545" y="7"/>
                    </a:lnTo>
                    <a:lnTo>
                      <a:pt x="545" y="14"/>
                    </a:lnTo>
                    <a:lnTo>
                      <a:pt x="553" y="14"/>
                    </a:lnTo>
                    <a:lnTo>
                      <a:pt x="553" y="7"/>
                    </a:lnTo>
                    <a:lnTo>
                      <a:pt x="560" y="7"/>
                    </a:lnTo>
                    <a:lnTo>
                      <a:pt x="567" y="7"/>
                    </a:lnTo>
                    <a:lnTo>
                      <a:pt x="574" y="7"/>
                    </a:lnTo>
                    <a:lnTo>
                      <a:pt x="581" y="7"/>
                    </a:lnTo>
                    <a:lnTo>
                      <a:pt x="588" y="7"/>
                    </a:lnTo>
                    <a:lnTo>
                      <a:pt x="595" y="7"/>
                    </a:lnTo>
                    <a:lnTo>
                      <a:pt x="595" y="14"/>
                    </a:lnTo>
                    <a:lnTo>
                      <a:pt x="602" y="7"/>
                    </a:lnTo>
                    <a:lnTo>
                      <a:pt x="609" y="7"/>
                    </a:lnTo>
                    <a:lnTo>
                      <a:pt x="616" y="7"/>
                    </a:lnTo>
                    <a:lnTo>
                      <a:pt x="623" y="7"/>
                    </a:lnTo>
                    <a:lnTo>
                      <a:pt x="630" y="14"/>
                    </a:lnTo>
                    <a:lnTo>
                      <a:pt x="630" y="0"/>
                    </a:lnTo>
                    <a:lnTo>
                      <a:pt x="638" y="7"/>
                    </a:lnTo>
                    <a:lnTo>
                      <a:pt x="645" y="7"/>
                    </a:lnTo>
                    <a:lnTo>
                      <a:pt x="652" y="7"/>
                    </a:lnTo>
                    <a:lnTo>
                      <a:pt x="652" y="14"/>
                    </a:lnTo>
                    <a:lnTo>
                      <a:pt x="659" y="14"/>
                    </a:lnTo>
                    <a:lnTo>
                      <a:pt x="659" y="7"/>
                    </a:lnTo>
                    <a:lnTo>
                      <a:pt x="666" y="7"/>
                    </a:lnTo>
                    <a:lnTo>
                      <a:pt x="666" y="14"/>
                    </a:lnTo>
                    <a:lnTo>
                      <a:pt x="673" y="14"/>
                    </a:lnTo>
                    <a:lnTo>
                      <a:pt x="673" y="7"/>
                    </a:lnTo>
                    <a:lnTo>
                      <a:pt x="680" y="7"/>
                    </a:lnTo>
                    <a:lnTo>
                      <a:pt x="687" y="7"/>
                    </a:lnTo>
                    <a:lnTo>
                      <a:pt x="687" y="0"/>
                    </a:lnTo>
                    <a:lnTo>
                      <a:pt x="694" y="0"/>
                    </a:lnTo>
                    <a:lnTo>
                      <a:pt x="694" y="7"/>
                    </a:lnTo>
                    <a:lnTo>
                      <a:pt x="701" y="7"/>
                    </a:lnTo>
                    <a:lnTo>
                      <a:pt x="701" y="0"/>
                    </a:lnTo>
                    <a:lnTo>
                      <a:pt x="708" y="0"/>
                    </a:lnTo>
                    <a:lnTo>
                      <a:pt x="708" y="7"/>
                    </a:lnTo>
                    <a:lnTo>
                      <a:pt x="716" y="7"/>
                    </a:lnTo>
                    <a:lnTo>
                      <a:pt x="716" y="14"/>
                    </a:lnTo>
                    <a:lnTo>
                      <a:pt x="723" y="7"/>
                    </a:lnTo>
                    <a:lnTo>
                      <a:pt x="730" y="7"/>
                    </a:lnTo>
                    <a:lnTo>
                      <a:pt x="737" y="7"/>
                    </a:lnTo>
                    <a:lnTo>
                      <a:pt x="737" y="14"/>
                    </a:lnTo>
                    <a:lnTo>
                      <a:pt x="744" y="7"/>
                    </a:lnTo>
                    <a:lnTo>
                      <a:pt x="751" y="7"/>
                    </a:lnTo>
                    <a:lnTo>
                      <a:pt x="758" y="7"/>
                    </a:lnTo>
                    <a:lnTo>
                      <a:pt x="758" y="14"/>
                    </a:lnTo>
                    <a:lnTo>
                      <a:pt x="765" y="7"/>
                    </a:lnTo>
                    <a:lnTo>
                      <a:pt x="772" y="7"/>
                    </a:lnTo>
                    <a:lnTo>
                      <a:pt x="779" y="7"/>
                    </a:lnTo>
                    <a:lnTo>
                      <a:pt x="779" y="14"/>
                    </a:lnTo>
                    <a:lnTo>
                      <a:pt x="786" y="7"/>
                    </a:lnTo>
                    <a:lnTo>
                      <a:pt x="793" y="7"/>
                    </a:lnTo>
                    <a:lnTo>
                      <a:pt x="793" y="14"/>
                    </a:lnTo>
                    <a:lnTo>
                      <a:pt x="801" y="14"/>
                    </a:lnTo>
                    <a:lnTo>
                      <a:pt x="801" y="7"/>
                    </a:lnTo>
                    <a:lnTo>
                      <a:pt x="808" y="7"/>
                    </a:lnTo>
                    <a:lnTo>
                      <a:pt x="815" y="7"/>
                    </a:lnTo>
                    <a:lnTo>
                      <a:pt x="815" y="14"/>
                    </a:lnTo>
                    <a:lnTo>
                      <a:pt x="822" y="14"/>
                    </a:lnTo>
                    <a:lnTo>
                      <a:pt x="822" y="7"/>
                    </a:lnTo>
                    <a:lnTo>
                      <a:pt x="829" y="7"/>
                    </a:lnTo>
                    <a:lnTo>
                      <a:pt x="836" y="7"/>
                    </a:lnTo>
                    <a:lnTo>
                      <a:pt x="836" y="14"/>
                    </a:lnTo>
                    <a:lnTo>
                      <a:pt x="843" y="14"/>
                    </a:lnTo>
                    <a:lnTo>
                      <a:pt x="843" y="7"/>
                    </a:lnTo>
                    <a:lnTo>
                      <a:pt x="850" y="7"/>
                    </a:lnTo>
                    <a:lnTo>
                      <a:pt x="850" y="14"/>
                    </a:lnTo>
                    <a:lnTo>
                      <a:pt x="857" y="14"/>
                    </a:lnTo>
                    <a:lnTo>
                      <a:pt x="857" y="7"/>
                    </a:lnTo>
                    <a:lnTo>
                      <a:pt x="864" y="7"/>
                    </a:lnTo>
                    <a:lnTo>
                      <a:pt x="871" y="7"/>
                    </a:lnTo>
                    <a:lnTo>
                      <a:pt x="879" y="7"/>
                    </a:lnTo>
                    <a:lnTo>
                      <a:pt x="879" y="14"/>
                    </a:lnTo>
                    <a:lnTo>
                      <a:pt x="886" y="7"/>
                    </a:lnTo>
                    <a:lnTo>
                      <a:pt x="893" y="7"/>
                    </a:lnTo>
                    <a:lnTo>
                      <a:pt x="893" y="14"/>
                    </a:lnTo>
                    <a:lnTo>
                      <a:pt x="900" y="14"/>
                    </a:lnTo>
                    <a:lnTo>
                      <a:pt x="907" y="14"/>
                    </a:lnTo>
                    <a:lnTo>
                      <a:pt x="907" y="7"/>
                    </a:lnTo>
                    <a:lnTo>
                      <a:pt x="914" y="7"/>
                    </a:lnTo>
                    <a:lnTo>
                      <a:pt x="914" y="14"/>
                    </a:lnTo>
                    <a:lnTo>
                      <a:pt x="921" y="14"/>
                    </a:lnTo>
                    <a:lnTo>
                      <a:pt x="921" y="21"/>
                    </a:lnTo>
                    <a:lnTo>
                      <a:pt x="928" y="14"/>
                    </a:lnTo>
                    <a:lnTo>
                      <a:pt x="928" y="7"/>
                    </a:lnTo>
                    <a:lnTo>
                      <a:pt x="935" y="7"/>
                    </a:lnTo>
                    <a:lnTo>
                      <a:pt x="935" y="21"/>
                    </a:lnTo>
                    <a:lnTo>
                      <a:pt x="942" y="21"/>
                    </a:lnTo>
                    <a:lnTo>
                      <a:pt x="942" y="14"/>
                    </a:lnTo>
                    <a:lnTo>
                      <a:pt x="949" y="14"/>
                    </a:lnTo>
                    <a:lnTo>
                      <a:pt x="949" y="7"/>
                    </a:lnTo>
                    <a:lnTo>
                      <a:pt x="956" y="7"/>
                    </a:lnTo>
                    <a:lnTo>
                      <a:pt x="956" y="14"/>
                    </a:lnTo>
                    <a:lnTo>
                      <a:pt x="964" y="14"/>
                    </a:lnTo>
                    <a:lnTo>
                      <a:pt x="971" y="14"/>
                    </a:lnTo>
                    <a:lnTo>
                      <a:pt x="971" y="21"/>
                    </a:lnTo>
                    <a:lnTo>
                      <a:pt x="978" y="21"/>
                    </a:lnTo>
                    <a:lnTo>
                      <a:pt x="978" y="14"/>
                    </a:lnTo>
                    <a:lnTo>
                      <a:pt x="985" y="14"/>
                    </a:lnTo>
                    <a:lnTo>
                      <a:pt x="985" y="21"/>
                    </a:lnTo>
                    <a:lnTo>
                      <a:pt x="992" y="21"/>
                    </a:lnTo>
                    <a:lnTo>
                      <a:pt x="992" y="14"/>
                    </a:lnTo>
                    <a:lnTo>
                      <a:pt x="999" y="14"/>
                    </a:lnTo>
                    <a:lnTo>
                      <a:pt x="1006" y="14"/>
                    </a:lnTo>
                    <a:lnTo>
                      <a:pt x="1006" y="21"/>
                    </a:lnTo>
                    <a:lnTo>
                      <a:pt x="1013" y="14"/>
                    </a:lnTo>
                    <a:lnTo>
                      <a:pt x="1020" y="14"/>
                    </a:lnTo>
                    <a:lnTo>
                      <a:pt x="1027" y="14"/>
                    </a:lnTo>
                    <a:lnTo>
                      <a:pt x="1027" y="7"/>
                    </a:lnTo>
                    <a:lnTo>
                      <a:pt x="1034" y="7"/>
                    </a:lnTo>
                    <a:lnTo>
                      <a:pt x="1034" y="14"/>
                    </a:lnTo>
                    <a:lnTo>
                      <a:pt x="1041" y="21"/>
                    </a:lnTo>
                    <a:lnTo>
                      <a:pt x="1041" y="7"/>
                    </a:lnTo>
                    <a:lnTo>
                      <a:pt x="1049" y="14"/>
                    </a:lnTo>
                    <a:lnTo>
                      <a:pt x="1056" y="14"/>
                    </a:lnTo>
                    <a:lnTo>
                      <a:pt x="1063" y="14"/>
                    </a:lnTo>
                    <a:lnTo>
                      <a:pt x="1070" y="14"/>
                    </a:lnTo>
                    <a:lnTo>
                      <a:pt x="1070" y="21"/>
                    </a:lnTo>
                    <a:lnTo>
                      <a:pt x="1077" y="14"/>
                    </a:lnTo>
                    <a:lnTo>
                      <a:pt x="1084" y="14"/>
                    </a:lnTo>
                    <a:lnTo>
                      <a:pt x="1084" y="7"/>
                    </a:lnTo>
                    <a:lnTo>
                      <a:pt x="1091" y="7"/>
                    </a:lnTo>
                    <a:lnTo>
                      <a:pt x="1091" y="21"/>
                    </a:lnTo>
                    <a:lnTo>
                      <a:pt x="1098" y="14"/>
                    </a:lnTo>
                    <a:lnTo>
                      <a:pt x="1105" y="14"/>
                    </a:lnTo>
                    <a:lnTo>
                      <a:pt x="1112" y="14"/>
                    </a:lnTo>
                    <a:lnTo>
                      <a:pt x="1119" y="14"/>
                    </a:lnTo>
                    <a:lnTo>
                      <a:pt x="1127" y="14"/>
                    </a:lnTo>
                    <a:lnTo>
                      <a:pt x="1127" y="7"/>
                    </a:lnTo>
                    <a:lnTo>
                      <a:pt x="1134" y="7"/>
                    </a:lnTo>
                    <a:lnTo>
                      <a:pt x="1134" y="14"/>
                    </a:lnTo>
                    <a:lnTo>
                      <a:pt x="1141" y="14"/>
                    </a:lnTo>
                    <a:lnTo>
                      <a:pt x="1148" y="14"/>
                    </a:lnTo>
                    <a:lnTo>
                      <a:pt x="1148" y="21"/>
                    </a:lnTo>
                    <a:lnTo>
                      <a:pt x="1155" y="21"/>
                    </a:lnTo>
                    <a:lnTo>
                      <a:pt x="1155" y="14"/>
                    </a:lnTo>
                    <a:lnTo>
                      <a:pt x="1162" y="14"/>
                    </a:lnTo>
                    <a:lnTo>
                      <a:pt x="1162" y="21"/>
                    </a:lnTo>
                    <a:lnTo>
                      <a:pt x="1169" y="14"/>
                    </a:lnTo>
                    <a:lnTo>
                      <a:pt x="1176" y="14"/>
                    </a:lnTo>
                    <a:lnTo>
                      <a:pt x="1183" y="14"/>
                    </a:lnTo>
                    <a:lnTo>
                      <a:pt x="1190" y="14"/>
                    </a:lnTo>
                    <a:lnTo>
                      <a:pt x="1190" y="21"/>
                    </a:lnTo>
                    <a:lnTo>
                      <a:pt x="1197" y="14"/>
                    </a:lnTo>
                    <a:lnTo>
                      <a:pt x="1197" y="7"/>
                    </a:lnTo>
                    <a:lnTo>
                      <a:pt x="1204" y="14"/>
                    </a:lnTo>
                    <a:lnTo>
                      <a:pt x="1212" y="14"/>
                    </a:lnTo>
                    <a:lnTo>
                      <a:pt x="1212" y="21"/>
                    </a:lnTo>
                    <a:lnTo>
                      <a:pt x="1219" y="21"/>
                    </a:lnTo>
                    <a:lnTo>
                      <a:pt x="1219" y="14"/>
                    </a:lnTo>
                    <a:lnTo>
                      <a:pt x="1226" y="14"/>
                    </a:lnTo>
                    <a:lnTo>
                      <a:pt x="1226" y="21"/>
                    </a:lnTo>
                    <a:lnTo>
                      <a:pt x="1233" y="21"/>
                    </a:lnTo>
                    <a:lnTo>
                      <a:pt x="1233" y="14"/>
                    </a:lnTo>
                    <a:lnTo>
                      <a:pt x="1240" y="14"/>
                    </a:lnTo>
                    <a:lnTo>
                      <a:pt x="1240" y="21"/>
                    </a:lnTo>
                    <a:lnTo>
                      <a:pt x="1247" y="21"/>
                    </a:lnTo>
                    <a:lnTo>
                      <a:pt x="1247" y="14"/>
                    </a:lnTo>
                    <a:lnTo>
                      <a:pt x="1254" y="14"/>
                    </a:lnTo>
                    <a:lnTo>
                      <a:pt x="1254" y="21"/>
                    </a:lnTo>
                    <a:lnTo>
                      <a:pt x="1261" y="21"/>
                    </a:lnTo>
                    <a:lnTo>
                      <a:pt x="1261" y="14"/>
                    </a:lnTo>
                    <a:lnTo>
                      <a:pt x="1268" y="14"/>
                    </a:lnTo>
                    <a:lnTo>
                      <a:pt x="1268" y="21"/>
                    </a:lnTo>
                    <a:lnTo>
                      <a:pt x="1275" y="28"/>
                    </a:lnTo>
                    <a:lnTo>
                      <a:pt x="1275" y="14"/>
                    </a:lnTo>
                    <a:lnTo>
                      <a:pt x="1282" y="21"/>
                    </a:lnTo>
                    <a:lnTo>
                      <a:pt x="1290" y="21"/>
                    </a:lnTo>
                    <a:lnTo>
                      <a:pt x="1290" y="14"/>
                    </a:lnTo>
                    <a:lnTo>
                      <a:pt x="1297" y="14"/>
                    </a:lnTo>
                    <a:lnTo>
                      <a:pt x="1297" y="21"/>
                    </a:lnTo>
                    <a:lnTo>
                      <a:pt x="1304" y="21"/>
                    </a:lnTo>
                    <a:lnTo>
                      <a:pt x="1304" y="14"/>
                    </a:lnTo>
                    <a:lnTo>
                      <a:pt x="1311" y="14"/>
                    </a:lnTo>
                    <a:lnTo>
                      <a:pt x="1311" y="21"/>
                    </a:lnTo>
                    <a:lnTo>
                      <a:pt x="1318" y="21"/>
                    </a:lnTo>
                    <a:lnTo>
                      <a:pt x="1318" y="14"/>
                    </a:lnTo>
                    <a:lnTo>
                      <a:pt x="1325" y="21"/>
                    </a:lnTo>
                    <a:lnTo>
                      <a:pt x="1332" y="21"/>
                    </a:lnTo>
                    <a:lnTo>
                      <a:pt x="1332" y="14"/>
                    </a:lnTo>
                    <a:lnTo>
                      <a:pt x="1339" y="14"/>
                    </a:lnTo>
                    <a:lnTo>
                      <a:pt x="1339" y="21"/>
                    </a:lnTo>
                    <a:lnTo>
                      <a:pt x="1346" y="21"/>
                    </a:lnTo>
                    <a:lnTo>
                      <a:pt x="1346" y="14"/>
                    </a:lnTo>
                    <a:lnTo>
                      <a:pt x="1353" y="21"/>
                    </a:lnTo>
                    <a:lnTo>
                      <a:pt x="1360" y="21"/>
                    </a:lnTo>
                    <a:lnTo>
                      <a:pt x="1360" y="28"/>
                    </a:lnTo>
                    <a:lnTo>
                      <a:pt x="1367" y="21"/>
                    </a:lnTo>
                    <a:lnTo>
                      <a:pt x="1367" y="14"/>
                    </a:lnTo>
                    <a:lnTo>
                      <a:pt x="1375" y="14"/>
                    </a:lnTo>
                    <a:lnTo>
                      <a:pt x="1375" y="7"/>
                    </a:lnTo>
                    <a:lnTo>
                      <a:pt x="1382" y="14"/>
                    </a:lnTo>
                    <a:lnTo>
                      <a:pt x="1382" y="21"/>
                    </a:lnTo>
                    <a:lnTo>
                      <a:pt x="1389" y="21"/>
                    </a:lnTo>
                    <a:lnTo>
                      <a:pt x="1389" y="14"/>
                    </a:lnTo>
                    <a:lnTo>
                      <a:pt x="1396" y="14"/>
                    </a:lnTo>
                    <a:lnTo>
                      <a:pt x="1396" y="21"/>
                    </a:lnTo>
                    <a:lnTo>
                      <a:pt x="1403" y="21"/>
                    </a:lnTo>
                    <a:lnTo>
                      <a:pt x="1403" y="14"/>
                    </a:lnTo>
                    <a:lnTo>
                      <a:pt x="1410" y="14"/>
                    </a:lnTo>
                    <a:lnTo>
                      <a:pt x="1410" y="21"/>
                    </a:lnTo>
                    <a:lnTo>
                      <a:pt x="1417" y="21"/>
                    </a:lnTo>
                    <a:lnTo>
                      <a:pt x="1417" y="14"/>
                    </a:lnTo>
                    <a:lnTo>
                      <a:pt x="1424" y="14"/>
                    </a:lnTo>
                    <a:lnTo>
                      <a:pt x="1424" y="21"/>
                    </a:lnTo>
                    <a:lnTo>
                      <a:pt x="1431" y="21"/>
                    </a:lnTo>
                    <a:lnTo>
                      <a:pt x="1431" y="14"/>
                    </a:lnTo>
                    <a:lnTo>
                      <a:pt x="1438" y="14"/>
                    </a:lnTo>
                    <a:lnTo>
                      <a:pt x="1445" y="14"/>
                    </a:lnTo>
                    <a:lnTo>
                      <a:pt x="1445" y="21"/>
                    </a:lnTo>
                    <a:lnTo>
                      <a:pt x="1452" y="21"/>
                    </a:lnTo>
                    <a:lnTo>
                      <a:pt x="1452" y="14"/>
                    </a:lnTo>
                    <a:lnTo>
                      <a:pt x="1460" y="14"/>
                    </a:lnTo>
                    <a:lnTo>
                      <a:pt x="1460" y="21"/>
                    </a:lnTo>
                    <a:lnTo>
                      <a:pt x="1467" y="21"/>
                    </a:lnTo>
                    <a:lnTo>
                      <a:pt x="1467" y="28"/>
                    </a:lnTo>
                    <a:lnTo>
                      <a:pt x="1474" y="21"/>
                    </a:lnTo>
                    <a:lnTo>
                      <a:pt x="1474" y="14"/>
                    </a:lnTo>
                    <a:lnTo>
                      <a:pt x="1481" y="14"/>
                    </a:lnTo>
                    <a:lnTo>
                      <a:pt x="1481" y="21"/>
                    </a:lnTo>
                    <a:lnTo>
                      <a:pt x="1488" y="21"/>
                    </a:lnTo>
                    <a:lnTo>
                      <a:pt x="1488" y="14"/>
                    </a:lnTo>
                    <a:lnTo>
                      <a:pt x="1495" y="21"/>
                    </a:lnTo>
                    <a:lnTo>
                      <a:pt x="1495" y="28"/>
                    </a:lnTo>
                    <a:lnTo>
                      <a:pt x="1502" y="21"/>
                    </a:lnTo>
                    <a:lnTo>
                      <a:pt x="1502" y="14"/>
                    </a:lnTo>
                    <a:lnTo>
                      <a:pt x="1509" y="14"/>
                    </a:lnTo>
                    <a:lnTo>
                      <a:pt x="1509" y="21"/>
                    </a:lnTo>
                    <a:lnTo>
                      <a:pt x="1516" y="21"/>
                    </a:lnTo>
                    <a:lnTo>
                      <a:pt x="1516" y="14"/>
                    </a:lnTo>
                    <a:lnTo>
                      <a:pt x="1523" y="14"/>
                    </a:lnTo>
                    <a:lnTo>
                      <a:pt x="1530" y="14"/>
                    </a:lnTo>
                    <a:lnTo>
                      <a:pt x="1538" y="14"/>
                    </a:lnTo>
                    <a:lnTo>
                      <a:pt x="1538" y="21"/>
                    </a:lnTo>
                    <a:lnTo>
                      <a:pt x="1545" y="21"/>
                    </a:lnTo>
                    <a:lnTo>
                      <a:pt x="1545" y="14"/>
                    </a:lnTo>
                    <a:lnTo>
                      <a:pt x="1552" y="14"/>
                    </a:lnTo>
                    <a:lnTo>
                      <a:pt x="1552" y="21"/>
                    </a:lnTo>
                    <a:lnTo>
                      <a:pt x="1559" y="21"/>
                    </a:lnTo>
                    <a:lnTo>
                      <a:pt x="1559" y="14"/>
                    </a:lnTo>
                    <a:lnTo>
                      <a:pt x="1566" y="14"/>
                    </a:lnTo>
                    <a:lnTo>
                      <a:pt x="1566" y="21"/>
                    </a:lnTo>
                    <a:lnTo>
                      <a:pt x="1573" y="21"/>
                    </a:lnTo>
                    <a:lnTo>
                      <a:pt x="1573" y="28"/>
                    </a:lnTo>
                    <a:lnTo>
                      <a:pt x="1580" y="21"/>
                    </a:lnTo>
                    <a:lnTo>
                      <a:pt x="1587" y="21"/>
                    </a:lnTo>
                    <a:lnTo>
                      <a:pt x="1587" y="14"/>
                    </a:lnTo>
                    <a:lnTo>
                      <a:pt x="1594" y="14"/>
                    </a:lnTo>
                    <a:lnTo>
                      <a:pt x="1594" y="21"/>
                    </a:lnTo>
                    <a:lnTo>
                      <a:pt x="1601" y="21"/>
                    </a:lnTo>
                    <a:lnTo>
                      <a:pt x="1601" y="14"/>
                    </a:lnTo>
                    <a:lnTo>
                      <a:pt x="1608" y="14"/>
                    </a:lnTo>
                    <a:lnTo>
                      <a:pt x="1608" y="28"/>
                    </a:lnTo>
                    <a:lnTo>
                      <a:pt x="1615" y="21"/>
                    </a:lnTo>
                    <a:lnTo>
                      <a:pt x="1615" y="14"/>
                    </a:lnTo>
                    <a:lnTo>
                      <a:pt x="1623" y="14"/>
                    </a:lnTo>
                    <a:lnTo>
                      <a:pt x="1623" y="21"/>
                    </a:lnTo>
                    <a:lnTo>
                      <a:pt x="1630" y="21"/>
                    </a:lnTo>
                    <a:lnTo>
                      <a:pt x="1630" y="14"/>
                    </a:lnTo>
                    <a:lnTo>
                      <a:pt x="1637" y="14"/>
                    </a:lnTo>
                    <a:lnTo>
                      <a:pt x="1637" y="28"/>
                    </a:lnTo>
                    <a:lnTo>
                      <a:pt x="1644" y="21"/>
                    </a:lnTo>
                    <a:lnTo>
                      <a:pt x="1651" y="21"/>
                    </a:lnTo>
                    <a:lnTo>
                      <a:pt x="1658" y="21"/>
                    </a:lnTo>
                    <a:lnTo>
                      <a:pt x="1665" y="21"/>
                    </a:lnTo>
                    <a:lnTo>
                      <a:pt x="1665" y="28"/>
                    </a:lnTo>
                    <a:lnTo>
                      <a:pt x="1672" y="21"/>
                    </a:lnTo>
                    <a:lnTo>
                      <a:pt x="1679" y="21"/>
                    </a:lnTo>
                    <a:lnTo>
                      <a:pt x="1686" y="21"/>
                    </a:lnTo>
                    <a:lnTo>
                      <a:pt x="1693" y="21"/>
                    </a:lnTo>
                    <a:lnTo>
                      <a:pt x="1701" y="21"/>
                    </a:lnTo>
                    <a:lnTo>
                      <a:pt x="1701" y="28"/>
                    </a:lnTo>
                    <a:lnTo>
                      <a:pt x="1708" y="28"/>
                    </a:lnTo>
                    <a:lnTo>
                      <a:pt x="1708" y="21"/>
                    </a:lnTo>
                    <a:lnTo>
                      <a:pt x="1715" y="21"/>
                    </a:lnTo>
                    <a:lnTo>
                      <a:pt x="1715" y="28"/>
                    </a:lnTo>
                    <a:lnTo>
                      <a:pt x="1722" y="28"/>
                    </a:lnTo>
                    <a:lnTo>
                      <a:pt x="1722" y="21"/>
                    </a:lnTo>
                    <a:lnTo>
                      <a:pt x="1729" y="21"/>
                    </a:lnTo>
                    <a:lnTo>
                      <a:pt x="1729" y="28"/>
                    </a:lnTo>
                    <a:lnTo>
                      <a:pt x="1736" y="21"/>
                    </a:lnTo>
                    <a:lnTo>
                      <a:pt x="1743" y="21"/>
                    </a:lnTo>
                    <a:lnTo>
                      <a:pt x="1743" y="28"/>
                    </a:lnTo>
                    <a:lnTo>
                      <a:pt x="1750" y="28"/>
                    </a:lnTo>
                    <a:lnTo>
                      <a:pt x="1750" y="21"/>
                    </a:lnTo>
                    <a:lnTo>
                      <a:pt x="1757" y="21"/>
                    </a:lnTo>
                    <a:lnTo>
                      <a:pt x="1757" y="28"/>
                    </a:lnTo>
                    <a:lnTo>
                      <a:pt x="1764" y="21"/>
                    </a:lnTo>
                    <a:lnTo>
                      <a:pt x="1771" y="21"/>
                    </a:lnTo>
                    <a:lnTo>
                      <a:pt x="1778" y="21"/>
                    </a:lnTo>
                    <a:lnTo>
                      <a:pt x="1778" y="28"/>
                    </a:lnTo>
                    <a:lnTo>
                      <a:pt x="1786" y="28"/>
                    </a:lnTo>
                    <a:lnTo>
                      <a:pt x="1786" y="21"/>
                    </a:lnTo>
                    <a:lnTo>
                      <a:pt x="1793" y="21"/>
                    </a:lnTo>
                    <a:lnTo>
                      <a:pt x="1793" y="28"/>
                    </a:lnTo>
                    <a:lnTo>
                      <a:pt x="1800" y="28"/>
                    </a:lnTo>
                    <a:lnTo>
                      <a:pt x="1800" y="21"/>
                    </a:lnTo>
                    <a:lnTo>
                      <a:pt x="1807" y="21"/>
                    </a:lnTo>
                    <a:lnTo>
                      <a:pt x="1807" y="28"/>
                    </a:lnTo>
                    <a:lnTo>
                      <a:pt x="1814" y="28"/>
                    </a:lnTo>
                    <a:lnTo>
                      <a:pt x="1814" y="21"/>
                    </a:lnTo>
                    <a:lnTo>
                      <a:pt x="1821" y="21"/>
                    </a:lnTo>
                    <a:lnTo>
                      <a:pt x="1821" y="28"/>
                    </a:lnTo>
                    <a:lnTo>
                      <a:pt x="1828" y="28"/>
                    </a:lnTo>
                    <a:lnTo>
                      <a:pt x="1828" y="21"/>
                    </a:lnTo>
                    <a:lnTo>
                      <a:pt x="1835" y="21"/>
                    </a:lnTo>
                    <a:lnTo>
                      <a:pt x="1835" y="28"/>
                    </a:lnTo>
                    <a:lnTo>
                      <a:pt x="1842" y="28"/>
                    </a:lnTo>
                    <a:lnTo>
                      <a:pt x="1842" y="21"/>
                    </a:lnTo>
                    <a:lnTo>
                      <a:pt x="1849" y="21"/>
                    </a:lnTo>
                    <a:lnTo>
                      <a:pt x="1849" y="28"/>
                    </a:lnTo>
                    <a:lnTo>
                      <a:pt x="1856" y="28"/>
                    </a:lnTo>
                    <a:lnTo>
                      <a:pt x="1856" y="21"/>
                    </a:lnTo>
                    <a:lnTo>
                      <a:pt x="1864" y="28"/>
                    </a:lnTo>
                    <a:lnTo>
                      <a:pt x="1864" y="14"/>
                    </a:lnTo>
                    <a:lnTo>
                      <a:pt x="1871" y="21"/>
                    </a:lnTo>
                    <a:lnTo>
                      <a:pt x="1871" y="28"/>
                    </a:lnTo>
                    <a:lnTo>
                      <a:pt x="1878" y="28"/>
                    </a:lnTo>
                    <a:lnTo>
                      <a:pt x="1878" y="21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1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Freeform 73"/>
              <p:cNvSpPr/>
              <p:nvPr/>
            </p:nvSpPr>
            <p:spPr>
              <a:xfrm>
                <a:off x="4422240" y="4400640"/>
                <a:ext cx="563400" cy="528840"/>
              </a:xfrm>
              <a:custGeom>
                <a:avLst/>
                <a:gdLst/>
                <a:ahLst/>
                <a:rect l="l" t="t" r="r" b="b"/>
                <a:pathLst>
                  <a:path w="1878" h="333">
                    <a:moveTo>
                      <a:pt x="0" y="49"/>
                    </a:moveTo>
                    <a:lnTo>
                      <a:pt x="7" y="49"/>
                    </a:lnTo>
                    <a:lnTo>
                      <a:pt x="7" y="56"/>
                    </a:lnTo>
                    <a:lnTo>
                      <a:pt x="14" y="56"/>
                    </a:lnTo>
                    <a:lnTo>
                      <a:pt x="14" y="49"/>
                    </a:lnTo>
                    <a:lnTo>
                      <a:pt x="21" y="49"/>
                    </a:lnTo>
                    <a:lnTo>
                      <a:pt x="21" y="42"/>
                    </a:lnTo>
                    <a:lnTo>
                      <a:pt x="28" y="42"/>
                    </a:lnTo>
                    <a:lnTo>
                      <a:pt x="28" y="49"/>
                    </a:lnTo>
                    <a:lnTo>
                      <a:pt x="35" y="49"/>
                    </a:lnTo>
                    <a:lnTo>
                      <a:pt x="42" y="49"/>
                    </a:lnTo>
                    <a:lnTo>
                      <a:pt x="42" y="56"/>
                    </a:lnTo>
                    <a:lnTo>
                      <a:pt x="49" y="56"/>
                    </a:lnTo>
                    <a:lnTo>
                      <a:pt x="49" y="49"/>
                    </a:lnTo>
                    <a:lnTo>
                      <a:pt x="56" y="49"/>
                    </a:lnTo>
                    <a:lnTo>
                      <a:pt x="56" y="56"/>
                    </a:lnTo>
                    <a:lnTo>
                      <a:pt x="63" y="64"/>
                    </a:lnTo>
                    <a:lnTo>
                      <a:pt x="63" y="49"/>
                    </a:lnTo>
                    <a:lnTo>
                      <a:pt x="71" y="49"/>
                    </a:lnTo>
                    <a:lnTo>
                      <a:pt x="71" y="56"/>
                    </a:lnTo>
                    <a:lnTo>
                      <a:pt x="78" y="56"/>
                    </a:lnTo>
                    <a:lnTo>
                      <a:pt x="78" y="49"/>
                    </a:lnTo>
                    <a:lnTo>
                      <a:pt x="85" y="49"/>
                    </a:lnTo>
                    <a:lnTo>
                      <a:pt x="85" y="56"/>
                    </a:lnTo>
                    <a:lnTo>
                      <a:pt x="92" y="56"/>
                    </a:lnTo>
                    <a:lnTo>
                      <a:pt x="92" y="49"/>
                    </a:lnTo>
                    <a:lnTo>
                      <a:pt x="99" y="49"/>
                    </a:lnTo>
                    <a:lnTo>
                      <a:pt x="99" y="56"/>
                    </a:lnTo>
                    <a:lnTo>
                      <a:pt x="106" y="49"/>
                    </a:lnTo>
                    <a:lnTo>
                      <a:pt x="113" y="49"/>
                    </a:lnTo>
                    <a:lnTo>
                      <a:pt x="120" y="49"/>
                    </a:lnTo>
                    <a:lnTo>
                      <a:pt x="120" y="56"/>
                    </a:lnTo>
                    <a:lnTo>
                      <a:pt x="127" y="56"/>
                    </a:lnTo>
                    <a:lnTo>
                      <a:pt x="127" y="49"/>
                    </a:lnTo>
                    <a:lnTo>
                      <a:pt x="134" y="49"/>
                    </a:lnTo>
                    <a:lnTo>
                      <a:pt x="134" y="56"/>
                    </a:lnTo>
                    <a:lnTo>
                      <a:pt x="141" y="56"/>
                    </a:lnTo>
                    <a:lnTo>
                      <a:pt x="141" y="49"/>
                    </a:lnTo>
                    <a:lnTo>
                      <a:pt x="148" y="49"/>
                    </a:lnTo>
                    <a:lnTo>
                      <a:pt x="148" y="64"/>
                    </a:lnTo>
                    <a:lnTo>
                      <a:pt x="156" y="56"/>
                    </a:lnTo>
                    <a:lnTo>
                      <a:pt x="156" y="49"/>
                    </a:lnTo>
                    <a:lnTo>
                      <a:pt x="163" y="49"/>
                    </a:lnTo>
                    <a:lnTo>
                      <a:pt x="163" y="56"/>
                    </a:lnTo>
                    <a:lnTo>
                      <a:pt x="170" y="56"/>
                    </a:lnTo>
                    <a:lnTo>
                      <a:pt x="170" y="49"/>
                    </a:lnTo>
                    <a:lnTo>
                      <a:pt x="177" y="49"/>
                    </a:lnTo>
                    <a:lnTo>
                      <a:pt x="177" y="56"/>
                    </a:lnTo>
                    <a:lnTo>
                      <a:pt x="184" y="56"/>
                    </a:lnTo>
                    <a:lnTo>
                      <a:pt x="191" y="56"/>
                    </a:lnTo>
                    <a:lnTo>
                      <a:pt x="191" y="64"/>
                    </a:lnTo>
                    <a:lnTo>
                      <a:pt x="198" y="56"/>
                    </a:lnTo>
                    <a:lnTo>
                      <a:pt x="205" y="56"/>
                    </a:lnTo>
                    <a:lnTo>
                      <a:pt x="205" y="49"/>
                    </a:lnTo>
                    <a:lnTo>
                      <a:pt x="212" y="49"/>
                    </a:lnTo>
                    <a:lnTo>
                      <a:pt x="212" y="56"/>
                    </a:lnTo>
                    <a:lnTo>
                      <a:pt x="219" y="56"/>
                    </a:lnTo>
                    <a:lnTo>
                      <a:pt x="219" y="49"/>
                    </a:lnTo>
                    <a:lnTo>
                      <a:pt x="226" y="49"/>
                    </a:lnTo>
                    <a:lnTo>
                      <a:pt x="226" y="56"/>
                    </a:lnTo>
                    <a:lnTo>
                      <a:pt x="234" y="56"/>
                    </a:lnTo>
                    <a:lnTo>
                      <a:pt x="234" y="49"/>
                    </a:lnTo>
                    <a:lnTo>
                      <a:pt x="241" y="56"/>
                    </a:lnTo>
                    <a:lnTo>
                      <a:pt x="241" y="64"/>
                    </a:lnTo>
                    <a:lnTo>
                      <a:pt x="248" y="56"/>
                    </a:lnTo>
                    <a:lnTo>
                      <a:pt x="255" y="56"/>
                    </a:lnTo>
                    <a:lnTo>
                      <a:pt x="255" y="49"/>
                    </a:lnTo>
                    <a:lnTo>
                      <a:pt x="262" y="49"/>
                    </a:lnTo>
                    <a:lnTo>
                      <a:pt x="262" y="56"/>
                    </a:lnTo>
                    <a:lnTo>
                      <a:pt x="269" y="56"/>
                    </a:lnTo>
                    <a:lnTo>
                      <a:pt x="269" y="49"/>
                    </a:lnTo>
                    <a:lnTo>
                      <a:pt x="276" y="49"/>
                    </a:lnTo>
                    <a:lnTo>
                      <a:pt x="276" y="56"/>
                    </a:lnTo>
                    <a:lnTo>
                      <a:pt x="283" y="56"/>
                    </a:lnTo>
                    <a:lnTo>
                      <a:pt x="283" y="49"/>
                    </a:lnTo>
                    <a:lnTo>
                      <a:pt x="290" y="49"/>
                    </a:lnTo>
                    <a:lnTo>
                      <a:pt x="290" y="56"/>
                    </a:lnTo>
                    <a:lnTo>
                      <a:pt x="297" y="56"/>
                    </a:lnTo>
                    <a:lnTo>
                      <a:pt x="304" y="56"/>
                    </a:lnTo>
                    <a:lnTo>
                      <a:pt x="304" y="49"/>
                    </a:lnTo>
                    <a:lnTo>
                      <a:pt x="311" y="49"/>
                    </a:lnTo>
                    <a:lnTo>
                      <a:pt x="311" y="56"/>
                    </a:lnTo>
                    <a:lnTo>
                      <a:pt x="319" y="56"/>
                    </a:lnTo>
                    <a:lnTo>
                      <a:pt x="319" y="49"/>
                    </a:lnTo>
                    <a:lnTo>
                      <a:pt x="326" y="49"/>
                    </a:lnTo>
                    <a:lnTo>
                      <a:pt x="326" y="56"/>
                    </a:lnTo>
                    <a:lnTo>
                      <a:pt x="333" y="56"/>
                    </a:lnTo>
                    <a:lnTo>
                      <a:pt x="333" y="49"/>
                    </a:lnTo>
                    <a:lnTo>
                      <a:pt x="340" y="56"/>
                    </a:lnTo>
                    <a:lnTo>
                      <a:pt x="340" y="64"/>
                    </a:lnTo>
                    <a:lnTo>
                      <a:pt x="347" y="64"/>
                    </a:lnTo>
                    <a:lnTo>
                      <a:pt x="347" y="56"/>
                    </a:lnTo>
                    <a:lnTo>
                      <a:pt x="354" y="56"/>
                    </a:lnTo>
                    <a:lnTo>
                      <a:pt x="361" y="56"/>
                    </a:lnTo>
                    <a:lnTo>
                      <a:pt x="361" y="49"/>
                    </a:lnTo>
                    <a:lnTo>
                      <a:pt x="368" y="49"/>
                    </a:lnTo>
                    <a:lnTo>
                      <a:pt x="368" y="56"/>
                    </a:lnTo>
                    <a:lnTo>
                      <a:pt x="375" y="56"/>
                    </a:lnTo>
                    <a:lnTo>
                      <a:pt x="375" y="49"/>
                    </a:lnTo>
                    <a:lnTo>
                      <a:pt x="382" y="49"/>
                    </a:lnTo>
                    <a:lnTo>
                      <a:pt x="382" y="56"/>
                    </a:lnTo>
                    <a:lnTo>
                      <a:pt x="389" y="56"/>
                    </a:lnTo>
                    <a:lnTo>
                      <a:pt x="397" y="56"/>
                    </a:lnTo>
                    <a:lnTo>
                      <a:pt x="404" y="56"/>
                    </a:lnTo>
                    <a:lnTo>
                      <a:pt x="404" y="64"/>
                    </a:lnTo>
                    <a:lnTo>
                      <a:pt x="411" y="64"/>
                    </a:lnTo>
                    <a:lnTo>
                      <a:pt x="411" y="56"/>
                    </a:lnTo>
                    <a:lnTo>
                      <a:pt x="418" y="56"/>
                    </a:lnTo>
                    <a:lnTo>
                      <a:pt x="418" y="49"/>
                    </a:lnTo>
                    <a:lnTo>
                      <a:pt x="425" y="49"/>
                    </a:lnTo>
                    <a:lnTo>
                      <a:pt x="425" y="56"/>
                    </a:lnTo>
                    <a:lnTo>
                      <a:pt x="432" y="56"/>
                    </a:lnTo>
                    <a:lnTo>
                      <a:pt x="432" y="49"/>
                    </a:lnTo>
                    <a:lnTo>
                      <a:pt x="439" y="49"/>
                    </a:lnTo>
                    <a:lnTo>
                      <a:pt x="439" y="56"/>
                    </a:lnTo>
                    <a:lnTo>
                      <a:pt x="446" y="56"/>
                    </a:lnTo>
                    <a:lnTo>
                      <a:pt x="453" y="56"/>
                    </a:lnTo>
                    <a:lnTo>
                      <a:pt x="460" y="56"/>
                    </a:lnTo>
                    <a:lnTo>
                      <a:pt x="460" y="64"/>
                    </a:lnTo>
                    <a:lnTo>
                      <a:pt x="467" y="64"/>
                    </a:lnTo>
                    <a:lnTo>
                      <a:pt x="467" y="56"/>
                    </a:lnTo>
                    <a:lnTo>
                      <a:pt x="474" y="56"/>
                    </a:lnTo>
                    <a:lnTo>
                      <a:pt x="482" y="56"/>
                    </a:lnTo>
                    <a:lnTo>
                      <a:pt x="482" y="64"/>
                    </a:lnTo>
                    <a:lnTo>
                      <a:pt x="489" y="56"/>
                    </a:lnTo>
                    <a:lnTo>
                      <a:pt x="496" y="56"/>
                    </a:lnTo>
                    <a:lnTo>
                      <a:pt x="496" y="49"/>
                    </a:lnTo>
                    <a:lnTo>
                      <a:pt x="503" y="49"/>
                    </a:lnTo>
                    <a:lnTo>
                      <a:pt x="503" y="56"/>
                    </a:lnTo>
                    <a:lnTo>
                      <a:pt x="510" y="64"/>
                    </a:lnTo>
                    <a:lnTo>
                      <a:pt x="510" y="49"/>
                    </a:lnTo>
                    <a:lnTo>
                      <a:pt x="517" y="49"/>
                    </a:lnTo>
                    <a:lnTo>
                      <a:pt x="517" y="56"/>
                    </a:lnTo>
                    <a:lnTo>
                      <a:pt x="524" y="64"/>
                    </a:lnTo>
                    <a:lnTo>
                      <a:pt x="524" y="49"/>
                    </a:lnTo>
                    <a:lnTo>
                      <a:pt x="531" y="56"/>
                    </a:lnTo>
                    <a:lnTo>
                      <a:pt x="531" y="64"/>
                    </a:lnTo>
                    <a:lnTo>
                      <a:pt x="538" y="64"/>
                    </a:lnTo>
                    <a:lnTo>
                      <a:pt x="538" y="56"/>
                    </a:lnTo>
                    <a:lnTo>
                      <a:pt x="545" y="56"/>
                    </a:lnTo>
                    <a:lnTo>
                      <a:pt x="545" y="64"/>
                    </a:lnTo>
                    <a:lnTo>
                      <a:pt x="552" y="56"/>
                    </a:lnTo>
                    <a:lnTo>
                      <a:pt x="559" y="56"/>
                    </a:lnTo>
                    <a:lnTo>
                      <a:pt x="567" y="56"/>
                    </a:lnTo>
                    <a:lnTo>
                      <a:pt x="567" y="49"/>
                    </a:lnTo>
                    <a:lnTo>
                      <a:pt x="574" y="49"/>
                    </a:lnTo>
                    <a:lnTo>
                      <a:pt x="574" y="56"/>
                    </a:lnTo>
                    <a:lnTo>
                      <a:pt x="581" y="56"/>
                    </a:lnTo>
                    <a:lnTo>
                      <a:pt x="588" y="56"/>
                    </a:lnTo>
                    <a:lnTo>
                      <a:pt x="595" y="56"/>
                    </a:lnTo>
                    <a:lnTo>
                      <a:pt x="595" y="64"/>
                    </a:lnTo>
                    <a:lnTo>
                      <a:pt x="602" y="64"/>
                    </a:lnTo>
                    <a:lnTo>
                      <a:pt x="602" y="56"/>
                    </a:lnTo>
                    <a:lnTo>
                      <a:pt x="609" y="56"/>
                    </a:lnTo>
                    <a:lnTo>
                      <a:pt x="609" y="64"/>
                    </a:lnTo>
                    <a:lnTo>
                      <a:pt x="616" y="64"/>
                    </a:lnTo>
                    <a:lnTo>
                      <a:pt x="616" y="56"/>
                    </a:lnTo>
                    <a:lnTo>
                      <a:pt x="623" y="56"/>
                    </a:lnTo>
                    <a:lnTo>
                      <a:pt x="623" y="64"/>
                    </a:lnTo>
                    <a:lnTo>
                      <a:pt x="630" y="64"/>
                    </a:lnTo>
                    <a:lnTo>
                      <a:pt x="630" y="56"/>
                    </a:lnTo>
                    <a:lnTo>
                      <a:pt x="637" y="56"/>
                    </a:lnTo>
                    <a:lnTo>
                      <a:pt x="637" y="64"/>
                    </a:lnTo>
                    <a:lnTo>
                      <a:pt x="645" y="64"/>
                    </a:lnTo>
                    <a:lnTo>
                      <a:pt x="645" y="56"/>
                    </a:lnTo>
                    <a:lnTo>
                      <a:pt x="652" y="56"/>
                    </a:lnTo>
                    <a:lnTo>
                      <a:pt x="652" y="64"/>
                    </a:lnTo>
                    <a:lnTo>
                      <a:pt x="659" y="64"/>
                    </a:lnTo>
                    <a:lnTo>
                      <a:pt x="659" y="56"/>
                    </a:lnTo>
                    <a:lnTo>
                      <a:pt x="666" y="56"/>
                    </a:lnTo>
                    <a:lnTo>
                      <a:pt x="666" y="64"/>
                    </a:lnTo>
                    <a:lnTo>
                      <a:pt x="673" y="56"/>
                    </a:lnTo>
                    <a:lnTo>
                      <a:pt x="680" y="56"/>
                    </a:lnTo>
                    <a:lnTo>
                      <a:pt x="680" y="64"/>
                    </a:lnTo>
                    <a:lnTo>
                      <a:pt x="687" y="64"/>
                    </a:lnTo>
                    <a:lnTo>
                      <a:pt x="687" y="56"/>
                    </a:lnTo>
                    <a:lnTo>
                      <a:pt x="694" y="56"/>
                    </a:lnTo>
                    <a:lnTo>
                      <a:pt x="694" y="64"/>
                    </a:lnTo>
                    <a:lnTo>
                      <a:pt x="701" y="64"/>
                    </a:lnTo>
                    <a:lnTo>
                      <a:pt x="701" y="56"/>
                    </a:lnTo>
                    <a:lnTo>
                      <a:pt x="708" y="56"/>
                    </a:lnTo>
                    <a:lnTo>
                      <a:pt x="708" y="64"/>
                    </a:lnTo>
                    <a:lnTo>
                      <a:pt x="715" y="64"/>
                    </a:lnTo>
                    <a:lnTo>
                      <a:pt x="715" y="56"/>
                    </a:lnTo>
                    <a:lnTo>
                      <a:pt x="722" y="56"/>
                    </a:lnTo>
                    <a:lnTo>
                      <a:pt x="722" y="64"/>
                    </a:lnTo>
                    <a:lnTo>
                      <a:pt x="730" y="64"/>
                    </a:lnTo>
                    <a:lnTo>
                      <a:pt x="730" y="56"/>
                    </a:lnTo>
                    <a:lnTo>
                      <a:pt x="737" y="64"/>
                    </a:lnTo>
                    <a:lnTo>
                      <a:pt x="737" y="71"/>
                    </a:lnTo>
                    <a:lnTo>
                      <a:pt x="744" y="64"/>
                    </a:lnTo>
                    <a:lnTo>
                      <a:pt x="751" y="64"/>
                    </a:lnTo>
                    <a:lnTo>
                      <a:pt x="751" y="71"/>
                    </a:lnTo>
                    <a:lnTo>
                      <a:pt x="758" y="64"/>
                    </a:lnTo>
                    <a:lnTo>
                      <a:pt x="758" y="56"/>
                    </a:lnTo>
                    <a:lnTo>
                      <a:pt x="765" y="56"/>
                    </a:lnTo>
                    <a:lnTo>
                      <a:pt x="765" y="64"/>
                    </a:lnTo>
                    <a:lnTo>
                      <a:pt x="772" y="64"/>
                    </a:lnTo>
                    <a:lnTo>
                      <a:pt x="772" y="56"/>
                    </a:lnTo>
                    <a:lnTo>
                      <a:pt x="779" y="56"/>
                    </a:lnTo>
                    <a:lnTo>
                      <a:pt x="779" y="64"/>
                    </a:lnTo>
                    <a:lnTo>
                      <a:pt x="786" y="64"/>
                    </a:lnTo>
                    <a:lnTo>
                      <a:pt x="786" y="56"/>
                    </a:lnTo>
                    <a:lnTo>
                      <a:pt x="793" y="64"/>
                    </a:lnTo>
                    <a:lnTo>
                      <a:pt x="793" y="71"/>
                    </a:lnTo>
                    <a:lnTo>
                      <a:pt x="800" y="71"/>
                    </a:lnTo>
                    <a:lnTo>
                      <a:pt x="800" y="64"/>
                    </a:lnTo>
                    <a:lnTo>
                      <a:pt x="808" y="64"/>
                    </a:lnTo>
                    <a:lnTo>
                      <a:pt x="808" y="56"/>
                    </a:lnTo>
                    <a:lnTo>
                      <a:pt x="815" y="64"/>
                    </a:lnTo>
                    <a:lnTo>
                      <a:pt x="822" y="64"/>
                    </a:lnTo>
                    <a:lnTo>
                      <a:pt x="829" y="64"/>
                    </a:lnTo>
                    <a:lnTo>
                      <a:pt x="829" y="56"/>
                    </a:lnTo>
                    <a:lnTo>
                      <a:pt x="836" y="64"/>
                    </a:lnTo>
                    <a:lnTo>
                      <a:pt x="836" y="71"/>
                    </a:lnTo>
                    <a:lnTo>
                      <a:pt x="843" y="64"/>
                    </a:lnTo>
                    <a:lnTo>
                      <a:pt x="843" y="56"/>
                    </a:lnTo>
                    <a:lnTo>
                      <a:pt x="850" y="56"/>
                    </a:lnTo>
                    <a:lnTo>
                      <a:pt x="850" y="71"/>
                    </a:lnTo>
                    <a:lnTo>
                      <a:pt x="857" y="64"/>
                    </a:lnTo>
                    <a:lnTo>
                      <a:pt x="864" y="64"/>
                    </a:lnTo>
                    <a:lnTo>
                      <a:pt x="864" y="56"/>
                    </a:lnTo>
                    <a:lnTo>
                      <a:pt x="871" y="64"/>
                    </a:lnTo>
                    <a:lnTo>
                      <a:pt x="878" y="64"/>
                    </a:lnTo>
                    <a:lnTo>
                      <a:pt x="885" y="64"/>
                    </a:lnTo>
                    <a:lnTo>
                      <a:pt x="885" y="71"/>
                    </a:lnTo>
                    <a:lnTo>
                      <a:pt x="893" y="71"/>
                    </a:lnTo>
                    <a:lnTo>
                      <a:pt x="893" y="64"/>
                    </a:lnTo>
                    <a:lnTo>
                      <a:pt x="900" y="64"/>
                    </a:lnTo>
                    <a:lnTo>
                      <a:pt x="900" y="71"/>
                    </a:lnTo>
                    <a:lnTo>
                      <a:pt x="907" y="71"/>
                    </a:lnTo>
                    <a:lnTo>
                      <a:pt x="907" y="64"/>
                    </a:lnTo>
                    <a:lnTo>
                      <a:pt x="914" y="71"/>
                    </a:lnTo>
                    <a:lnTo>
                      <a:pt x="914" y="0"/>
                    </a:lnTo>
                    <a:lnTo>
                      <a:pt x="921" y="71"/>
                    </a:lnTo>
                    <a:lnTo>
                      <a:pt x="921" y="106"/>
                    </a:lnTo>
                    <a:lnTo>
                      <a:pt x="928" y="113"/>
                    </a:lnTo>
                    <a:lnTo>
                      <a:pt x="928" y="205"/>
                    </a:lnTo>
                    <a:lnTo>
                      <a:pt x="935" y="219"/>
                    </a:lnTo>
                    <a:lnTo>
                      <a:pt x="935" y="191"/>
                    </a:lnTo>
                    <a:lnTo>
                      <a:pt x="942" y="219"/>
                    </a:lnTo>
                    <a:lnTo>
                      <a:pt x="942" y="276"/>
                    </a:lnTo>
                    <a:lnTo>
                      <a:pt x="949" y="276"/>
                    </a:lnTo>
                    <a:lnTo>
                      <a:pt x="949" y="319"/>
                    </a:lnTo>
                    <a:lnTo>
                      <a:pt x="956" y="326"/>
                    </a:lnTo>
                    <a:lnTo>
                      <a:pt x="956" y="312"/>
                    </a:lnTo>
                    <a:lnTo>
                      <a:pt x="963" y="326"/>
                    </a:lnTo>
                    <a:lnTo>
                      <a:pt x="963" y="333"/>
                    </a:lnTo>
                    <a:lnTo>
                      <a:pt x="970" y="333"/>
                    </a:lnTo>
                    <a:lnTo>
                      <a:pt x="978" y="333"/>
                    </a:lnTo>
                    <a:lnTo>
                      <a:pt x="978" y="326"/>
                    </a:lnTo>
                    <a:lnTo>
                      <a:pt x="985" y="326"/>
                    </a:lnTo>
                    <a:lnTo>
                      <a:pt x="985" y="333"/>
                    </a:lnTo>
                    <a:lnTo>
                      <a:pt x="992" y="333"/>
                    </a:lnTo>
                    <a:lnTo>
                      <a:pt x="992" y="326"/>
                    </a:lnTo>
                    <a:lnTo>
                      <a:pt x="999" y="326"/>
                    </a:lnTo>
                    <a:lnTo>
                      <a:pt x="999" y="333"/>
                    </a:lnTo>
                    <a:lnTo>
                      <a:pt x="1006" y="333"/>
                    </a:lnTo>
                    <a:lnTo>
                      <a:pt x="1006" y="326"/>
                    </a:lnTo>
                    <a:lnTo>
                      <a:pt x="1013" y="326"/>
                    </a:lnTo>
                    <a:lnTo>
                      <a:pt x="1013" y="333"/>
                    </a:lnTo>
                    <a:lnTo>
                      <a:pt x="1020" y="333"/>
                    </a:lnTo>
                    <a:lnTo>
                      <a:pt x="1020" y="326"/>
                    </a:lnTo>
                    <a:lnTo>
                      <a:pt x="1027" y="326"/>
                    </a:lnTo>
                    <a:lnTo>
                      <a:pt x="1034" y="326"/>
                    </a:lnTo>
                    <a:lnTo>
                      <a:pt x="1034" y="333"/>
                    </a:lnTo>
                    <a:lnTo>
                      <a:pt x="1041" y="333"/>
                    </a:lnTo>
                    <a:lnTo>
                      <a:pt x="1041" y="326"/>
                    </a:lnTo>
                    <a:lnTo>
                      <a:pt x="1048" y="333"/>
                    </a:lnTo>
                    <a:lnTo>
                      <a:pt x="1056" y="333"/>
                    </a:lnTo>
                    <a:lnTo>
                      <a:pt x="1063" y="333"/>
                    </a:lnTo>
                    <a:lnTo>
                      <a:pt x="1070" y="333"/>
                    </a:lnTo>
                    <a:lnTo>
                      <a:pt x="1077" y="333"/>
                    </a:lnTo>
                    <a:lnTo>
                      <a:pt x="1084" y="333"/>
                    </a:lnTo>
                    <a:lnTo>
                      <a:pt x="1091" y="333"/>
                    </a:lnTo>
                    <a:lnTo>
                      <a:pt x="1098" y="333"/>
                    </a:lnTo>
                    <a:lnTo>
                      <a:pt x="1105" y="333"/>
                    </a:lnTo>
                    <a:lnTo>
                      <a:pt x="1105" y="326"/>
                    </a:lnTo>
                    <a:lnTo>
                      <a:pt x="1112" y="326"/>
                    </a:lnTo>
                    <a:lnTo>
                      <a:pt x="1112" y="333"/>
                    </a:lnTo>
                    <a:lnTo>
                      <a:pt x="1119" y="333"/>
                    </a:lnTo>
                    <a:lnTo>
                      <a:pt x="1119" y="326"/>
                    </a:lnTo>
                    <a:lnTo>
                      <a:pt x="1126" y="326"/>
                    </a:lnTo>
                    <a:lnTo>
                      <a:pt x="1133" y="326"/>
                    </a:lnTo>
                    <a:lnTo>
                      <a:pt x="1141" y="326"/>
                    </a:lnTo>
                    <a:lnTo>
                      <a:pt x="1148" y="326"/>
                    </a:lnTo>
                    <a:lnTo>
                      <a:pt x="1148" y="319"/>
                    </a:lnTo>
                    <a:lnTo>
                      <a:pt x="1155" y="319"/>
                    </a:lnTo>
                    <a:lnTo>
                      <a:pt x="1155" y="326"/>
                    </a:lnTo>
                    <a:lnTo>
                      <a:pt x="1162" y="326"/>
                    </a:lnTo>
                    <a:lnTo>
                      <a:pt x="1162" y="333"/>
                    </a:lnTo>
                    <a:lnTo>
                      <a:pt x="1169" y="333"/>
                    </a:lnTo>
                    <a:lnTo>
                      <a:pt x="1169" y="326"/>
                    </a:lnTo>
                    <a:lnTo>
                      <a:pt x="1176" y="326"/>
                    </a:lnTo>
                    <a:lnTo>
                      <a:pt x="1176" y="333"/>
                    </a:lnTo>
                    <a:lnTo>
                      <a:pt x="1183" y="333"/>
                    </a:lnTo>
                    <a:lnTo>
                      <a:pt x="1183" y="326"/>
                    </a:lnTo>
                    <a:lnTo>
                      <a:pt x="1190" y="333"/>
                    </a:lnTo>
                    <a:lnTo>
                      <a:pt x="1197" y="333"/>
                    </a:lnTo>
                    <a:lnTo>
                      <a:pt x="1197" y="326"/>
                    </a:lnTo>
                    <a:lnTo>
                      <a:pt x="1204" y="326"/>
                    </a:lnTo>
                    <a:lnTo>
                      <a:pt x="1204" y="333"/>
                    </a:lnTo>
                    <a:lnTo>
                      <a:pt x="1211" y="326"/>
                    </a:lnTo>
                    <a:lnTo>
                      <a:pt x="1219" y="326"/>
                    </a:lnTo>
                    <a:lnTo>
                      <a:pt x="1226" y="326"/>
                    </a:lnTo>
                    <a:lnTo>
                      <a:pt x="1226" y="319"/>
                    </a:lnTo>
                    <a:lnTo>
                      <a:pt x="1233" y="319"/>
                    </a:lnTo>
                    <a:lnTo>
                      <a:pt x="1233" y="326"/>
                    </a:lnTo>
                    <a:lnTo>
                      <a:pt x="1240" y="326"/>
                    </a:lnTo>
                    <a:lnTo>
                      <a:pt x="1240" y="319"/>
                    </a:lnTo>
                    <a:lnTo>
                      <a:pt x="1247" y="326"/>
                    </a:lnTo>
                    <a:lnTo>
                      <a:pt x="1254" y="326"/>
                    </a:lnTo>
                    <a:lnTo>
                      <a:pt x="1254" y="333"/>
                    </a:lnTo>
                    <a:lnTo>
                      <a:pt x="1261" y="333"/>
                    </a:lnTo>
                    <a:lnTo>
                      <a:pt x="1261" y="326"/>
                    </a:lnTo>
                    <a:lnTo>
                      <a:pt x="1268" y="326"/>
                    </a:lnTo>
                    <a:lnTo>
                      <a:pt x="1268" y="333"/>
                    </a:lnTo>
                    <a:lnTo>
                      <a:pt x="1275" y="333"/>
                    </a:lnTo>
                    <a:lnTo>
                      <a:pt x="1282" y="333"/>
                    </a:lnTo>
                    <a:lnTo>
                      <a:pt x="1289" y="333"/>
                    </a:lnTo>
                    <a:lnTo>
                      <a:pt x="1289" y="326"/>
                    </a:lnTo>
                    <a:lnTo>
                      <a:pt x="1296" y="326"/>
                    </a:lnTo>
                    <a:lnTo>
                      <a:pt x="1296" y="333"/>
                    </a:lnTo>
                    <a:lnTo>
                      <a:pt x="1304" y="326"/>
                    </a:lnTo>
                    <a:lnTo>
                      <a:pt x="1311" y="326"/>
                    </a:lnTo>
                    <a:lnTo>
                      <a:pt x="1318" y="326"/>
                    </a:lnTo>
                    <a:lnTo>
                      <a:pt x="1318" y="319"/>
                    </a:lnTo>
                    <a:lnTo>
                      <a:pt x="1325" y="326"/>
                    </a:lnTo>
                    <a:lnTo>
                      <a:pt x="1332" y="326"/>
                    </a:lnTo>
                    <a:lnTo>
                      <a:pt x="1332" y="319"/>
                    </a:lnTo>
                    <a:lnTo>
                      <a:pt x="1339" y="319"/>
                    </a:lnTo>
                    <a:lnTo>
                      <a:pt x="1339" y="326"/>
                    </a:lnTo>
                    <a:lnTo>
                      <a:pt x="1346" y="326"/>
                    </a:lnTo>
                    <a:lnTo>
                      <a:pt x="1346" y="319"/>
                    </a:lnTo>
                    <a:lnTo>
                      <a:pt x="1353" y="319"/>
                    </a:lnTo>
                    <a:lnTo>
                      <a:pt x="1353" y="326"/>
                    </a:lnTo>
                    <a:lnTo>
                      <a:pt x="1360" y="326"/>
                    </a:lnTo>
                    <a:lnTo>
                      <a:pt x="1367" y="326"/>
                    </a:lnTo>
                    <a:lnTo>
                      <a:pt x="1374" y="326"/>
                    </a:lnTo>
                    <a:lnTo>
                      <a:pt x="1381" y="326"/>
                    </a:lnTo>
                    <a:lnTo>
                      <a:pt x="1389" y="326"/>
                    </a:lnTo>
                    <a:lnTo>
                      <a:pt x="1396" y="326"/>
                    </a:lnTo>
                    <a:lnTo>
                      <a:pt x="1396" y="319"/>
                    </a:lnTo>
                    <a:lnTo>
                      <a:pt x="1403" y="326"/>
                    </a:lnTo>
                    <a:lnTo>
                      <a:pt x="1410" y="326"/>
                    </a:lnTo>
                    <a:lnTo>
                      <a:pt x="1410" y="319"/>
                    </a:lnTo>
                    <a:lnTo>
                      <a:pt x="1417" y="326"/>
                    </a:lnTo>
                    <a:lnTo>
                      <a:pt x="1424" y="326"/>
                    </a:lnTo>
                    <a:lnTo>
                      <a:pt x="1424" y="319"/>
                    </a:lnTo>
                    <a:lnTo>
                      <a:pt x="1431" y="319"/>
                    </a:lnTo>
                    <a:lnTo>
                      <a:pt x="1431" y="326"/>
                    </a:lnTo>
                    <a:lnTo>
                      <a:pt x="1438" y="326"/>
                    </a:lnTo>
                    <a:lnTo>
                      <a:pt x="1438" y="319"/>
                    </a:lnTo>
                    <a:lnTo>
                      <a:pt x="1445" y="319"/>
                    </a:lnTo>
                    <a:lnTo>
                      <a:pt x="1445" y="326"/>
                    </a:lnTo>
                    <a:lnTo>
                      <a:pt x="1452" y="326"/>
                    </a:lnTo>
                    <a:lnTo>
                      <a:pt x="1452" y="319"/>
                    </a:lnTo>
                    <a:lnTo>
                      <a:pt x="1459" y="319"/>
                    </a:lnTo>
                    <a:lnTo>
                      <a:pt x="1459" y="326"/>
                    </a:lnTo>
                    <a:lnTo>
                      <a:pt x="1467" y="326"/>
                    </a:lnTo>
                    <a:lnTo>
                      <a:pt x="1467" y="319"/>
                    </a:lnTo>
                    <a:lnTo>
                      <a:pt x="1474" y="319"/>
                    </a:lnTo>
                    <a:lnTo>
                      <a:pt x="1474" y="326"/>
                    </a:lnTo>
                    <a:lnTo>
                      <a:pt x="1481" y="326"/>
                    </a:lnTo>
                    <a:lnTo>
                      <a:pt x="1481" y="319"/>
                    </a:lnTo>
                    <a:lnTo>
                      <a:pt x="1488" y="319"/>
                    </a:lnTo>
                    <a:lnTo>
                      <a:pt x="1488" y="326"/>
                    </a:lnTo>
                    <a:lnTo>
                      <a:pt x="1495" y="326"/>
                    </a:lnTo>
                    <a:lnTo>
                      <a:pt x="1495" y="319"/>
                    </a:lnTo>
                    <a:lnTo>
                      <a:pt x="1502" y="319"/>
                    </a:lnTo>
                    <a:lnTo>
                      <a:pt x="1502" y="326"/>
                    </a:lnTo>
                    <a:lnTo>
                      <a:pt x="1509" y="326"/>
                    </a:lnTo>
                    <a:lnTo>
                      <a:pt x="1509" y="319"/>
                    </a:lnTo>
                    <a:lnTo>
                      <a:pt x="1516" y="319"/>
                    </a:lnTo>
                    <a:lnTo>
                      <a:pt x="1516" y="326"/>
                    </a:lnTo>
                    <a:lnTo>
                      <a:pt x="1523" y="326"/>
                    </a:lnTo>
                    <a:lnTo>
                      <a:pt x="1523" y="319"/>
                    </a:lnTo>
                    <a:lnTo>
                      <a:pt x="1530" y="319"/>
                    </a:lnTo>
                    <a:lnTo>
                      <a:pt x="1530" y="326"/>
                    </a:lnTo>
                    <a:lnTo>
                      <a:pt x="1537" y="326"/>
                    </a:lnTo>
                    <a:lnTo>
                      <a:pt x="1537" y="319"/>
                    </a:lnTo>
                    <a:lnTo>
                      <a:pt x="1544" y="319"/>
                    </a:lnTo>
                    <a:lnTo>
                      <a:pt x="1552" y="319"/>
                    </a:lnTo>
                    <a:lnTo>
                      <a:pt x="1552" y="326"/>
                    </a:lnTo>
                    <a:lnTo>
                      <a:pt x="1559" y="319"/>
                    </a:lnTo>
                    <a:lnTo>
                      <a:pt x="1559" y="312"/>
                    </a:lnTo>
                    <a:lnTo>
                      <a:pt x="1566" y="312"/>
                    </a:lnTo>
                    <a:lnTo>
                      <a:pt x="1566" y="319"/>
                    </a:lnTo>
                    <a:lnTo>
                      <a:pt x="1573" y="319"/>
                    </a:lnTo>
                    <a:lnTo>
                      <a:pt x="1573" y="312"/>
                    </a:lnTo>
                    <a:lnTo>
                      <a:pt x="1580" y="312"/>
                    </a:lnTo>
                    <a:lnTo>
                      <a:pt x="1580" y="319"/>
                    </a:lnTo>
                    <a:lnTo>
                      <a:pt x="1587" y="319"/>
                    </a:lnTo>
                    <a:lnTo>
                      <a:pt x="1587" y="312"/>
                    </a:lnTo>
                    <a:lnTo>
                      <a:pt x="1594" y="312"/>
                    </a:lnTo>
                    <a:lnTo>
                      <a:pt x="1594" y="319"/>
                    </a:lnTo>
                    <a:lnTo>
                      <a:pt x="1601" y="319"/>
                    </a:lnTo>
                    <a:lnTo>
                      <a:pt x="1601" y="312"/>
                    </a:lnTo>
                    <a:lnTo>
                      <a:pt x="1608" y="312"/>
                    </a:lnTo>
                    <a:lnTo>
                      <a:pt x="1608" y="319"/>
                    </a:lnTo>
                    <a:lnTo>
                      <a:pt x="1615" y="319"/>
                    </a:lnTo>
                    <a:lnTo>
                      <a:pt x="1615" y="312"/>
                    </a:lnTo>
                    <a:lnTo>
                      <a:pt x="1622" y="312"/>
                    </a:lnTo>
                    <a:lnTo>
                      <a:pt x="1622" y="319"/>
                    </a:lnTo>
                    <a:lnTo>
                      <a:pt x="1630" y="319"/>
                    </a:lnTo>
                    <a:lnTo>
                      <a:pt x="1630" y="312"/>
                    </a:lnTo>
                    <a:lnTo>
                      <a:pt x="1637" y="312"/>
                    </a:lnTo>
                    <a:lnTo>
                      <a:pt x="1637" y="319"/>
                    </a:lnTo>
                    <a:lnTo>
                      <a:pt x="1644" y="319"/>
                    </a:lnTo>
                    <a:lnTo>
                      <a:pt x="1644" y="312"/>
                    </a:lnTo>
                    <a:lnTo>
                      <a:pt x="1651" y="312"/>
                    </a:lnTo>
                    <a:lnTo>
                      <a:pt x="1651" y="319"/>
                    </a:lnTo>
                    <a:lnTo>
                      <a:pt x="1658" y="319"/>
                    </a:lnTo>
                    <a:lnTo>
                      <a:pt x="1658" y="312"/>
                    </a:lnTo>
                    <a:lnTo>
                      <a:pt x="1665" y="319"/>
                    </a:lnTo>
                    <a:lnTo>
                      <a:pt x="1672" y="319"/>
                    </a:lnTo>
                    <a:lnTo>
                      <a:pt x="1672" y="326"/>
                    </a:lnTo>
                    <a:lnTo>
                      <a:pt x="1679" y="326"/>
                    </a:lnTo>
                    <a:lnTo>
                      <a:pt x="1679" y="319"/>
                    </a:lnTo>
                    <a:lnTo>
                      <a:pt x="1686" y="319"/>
                    </a:lnTo>
                    <a:lnTo>
                      <a:pt x="1686" y="326"/>
                    </a:lnTo>
                    <a:lnTo>
                      <a:pt x="1693" y="326"/>
                    </a:lnTo>
                    <a:lnTo>
                      <a:pt x="1693" y="319"/>
                    </a:lnTo>
                    <a:lnTo>
                      <a:pt x="1700" y="319"/>
                    </a:lnTo>
                    <a:lnTo>
                      <a:pt x="1700" y="326"/>
                    </a:lnTo>
                    <a:lnTo>
                      <a:pt x="1707" y="319"/>
                    </a:lnTo>
                    <a:lnTo>
                      <a:pt x="1715" y="319"/>
                    </a:lnTo>
                    <a:lnTo>
                      <a:pt x="1715" y="312"/>
                    </a:lnTo>
                    <a:lnTo>
                      <a:pt x="1722" y="312"/>
                    </a:lnTo>
                    <a:lnTo>
                      <a:pt x="1729" y="312"/>
                    </a:lnTo>
                    <a:lnTo>
                      <a:pt x="1736" y="312"/>
                    </a:lnTo>
                    <a:lnTo>
                      <a:pt x="1736" y="319"/>
                    </a:lnTo>
                    <a:lnTo>
                      <a:pt x="1743" y="319"/>
                    </a:lnTo>
                    <a:lnTo>
                      <a:pt x="1743" y="312"/>
                    </a:lnTo>
                    <a:lnTo>
                      <a:pt x="1750" y="312"/>
                    </a:lnTo>
                    <a:lnTo>
                      <a:pt x="1750" y="319"/>
                    </a:lnTo>
                    <a:lnTo>
                      <a:pt x="1757" y="319"/>
                    </a:lnTo>
                    <a:lnTo>
                      <a:pt x="1764" y="319"/>
                    </a:lnTo>
                    <a:lnTo>
                      <a:pt x="1771" y="319"/>
                    </a:lnTo>
                    <a:lnTo>
                      <a:pt x="1771" y="312"/>
                    </a:lnTo>
                    <a:lnTo>
                      <a:pt x="1778" y="312"/>
                    </a:lnTo>
                    <a:lnTo>
                      <a:pt x="1778" y="319"/>
                    </a:lnTo>
                    <a:lnTo>
                      <a:pt x="1785" y="312"/>
                    </a:lnTo>
                    <a:lnTo>
                      <a:pt x="1792" y="312"/>
                    </a:lnTo>
                    <a:lnTo>
                      <a:pt x="1800" y="312"/>
                    </a:lnTo>
                    <a:lnTo>
                      <a:pt x="1807" y="312"/>
                    </a:lnTo>
                    <a:lnTo>
                      <a:pt x="1814" y="312"/>
                    </a:lnTo>
                    <a:lnTo>
                      <a:pt x="1821" y="312"/>
                    </a:lnTo>
                    <a:lnTo>
                      <a:pt x="1821" y="319"/>
                    </a:lnTo>
                    <a:lnTo>
                      <a:pt x="1828" y="319"/>
                    </a:lnTo>
                    <a:lnTo>
                      <a:pt x="1828" y="312"/>
                    </a:lnTo>
                    <a:lnTo>
                      <a:pt x="1835" y="312"/>
                    </a:lnTo>
                    <a:lnTo>
                      <a:pt x="1835" y="319"/>
                    </a:lnTo>
                    <a:lnTo>
                      <a:pt x="1842" y="319"/>
                    </a:lnTo>
                    <a:lnTo>
                      <a:pt x="1842" y="312"/>
                    </a:lnTo>
                    <a:lnTo>
                      <a:pt x="1849" y="312"/>
                    </a:lnTo>
                    <a:lnTo>
                      <a:pt x="1849" y="305"/>
                    </a:lnTo>
                    <a:lnTo>
                      <a:pt x="1856" y="305"/>
                    </a:lnTo>
                    <a:lnTo>
                      <a:pt x="1856" y="312"/>
                    </a:lnTo>
                    <a:lnTo>
                      <a:pt x="1863" y="312"/>
                    </a:lnTo>
                    <a:lnTo>
                      <a:pt x="1863" y="319"/>
                    </a:lnTo>
                    <a:lnTo>
                      <a:pt x="1870" y="319"/>
                    </a:lnTo>
                    <a:lnTo>
                      <a:pt x="1870" y="312"/>
                    </a:lnTo>
                    <a:lnTo>
                      <a:pt x="1878" y="319"/>
                    </a:lnTo>
                    <a:lnTo>
                      <a:pt x="1878" y="31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Freeform 74"/>
              <p:cNvSpPr/>
              <p:nvPr/>
            </p:nvSpPr>
            <p:spPr>
              <a:xfrm>
                <a:off x="4985640" y="4884840"/>
                <a:ext cx="33840" cy="66600"/>
              </a:xfrm>
              <a:custGeom>
                <a:avLst/>
                <a:gdLst/>
                <a:ahLst/>
                <a:rect l="l" t="t" r="r" b="b"/>
                <a:pathLst>
                  <a:path w="113" h="42">
                    <a:moveTo>
                      <a:pt x="0" y="7"/>
                    </a:moveTo>
                    <a:lnTo>
                      <a:pt x="7" y="7"/>
                    </a:lnTo>
                    <a:lnTo>
                      <a:pt x="14" y="7"/>
                    </a:lnTo>
                    <a:lnTo>
                      <a:pt x="14" y="0"/>
                    </a:lnTo>
                    <a:lnTo>
                      <a:pt x="21" y="0"/>
                    </a:lnTo>
                    <a:lnTo>
                      <a:pt x="21" y="7"/>
                    </a:lnTo>
                    <a:lnTo>
                      <a:pt x="28" y="7"/>
                    </a:lnTo>
                    <a:lnTo>
                      <a:pt x="28" y="0"/>
                    </a:lnTo>
                    <a:lnTo>
                      <a:pt x="35" y="7"/>
                    </a:lnTo>
                    <a:lnTo>
                      <a:pt x="42" y="7"/>
                    </a:lnTo>
                    <a:lnTo>
                      <a:pt x="42" y="14"/>
                    </a:lnTo>
                    <a:lnTo>
                      <a:pt x="49" y="14"/>
                    </a:lnTo>
                    <a:lnTo>
                      <a:pt x="49" y="7"/>
                    </a:lnTo>
                    <a:lnTo>
                      <a:pt x="56" y="7"/>
                    </a:lnTo>
                    <a:lnTo>
                      <a:pt x="56" y="14"/>
                    </a:lnTo>
                    <a:lnTo>
                      <a:pt x="63" y="14"/>
                    </a:lnTo>
                    <a:lnTo>
                      <a:pt x="63" y="7"/>
                    </a:lnTo>
                    <a:lnTo>
                      <a:pt x="70" y="14"/>
                    </a:lnTo>
                    <a:lnTo>
                      <a:pt x="70" y="28"/>
                    </a:lnTo>
                    <a:lnTo>
                      <a:pt x="77" y="28"/>
                    </a:lnTo>
                    <a:lnTo>
                      <a:pt x="85" y="28"/>
                    </a:lnTo>
                    <a:lnTo>
                      <a:pt x="85" y="35"/>
                    </a:lnTo>
                    <a:lnTo>
                      <a:pt x="92" y="35"/>
                    </a:lnTo>
                    <a:lnTo>
                      <a:pt x="99" y="35"/>
                    </a:lnTo>
                    <a:lnTo>
                      <a:pt x="99" y="42"/>
                    </a:lnTo>
                    <a:lnTo>
                      <a:pt x="106" y="35"/>
                    </a:lnTo>
                    <a:lnTo>
                      <a:pt x="106" y="28"/>
                    </a:lnTo>
                    <a:lnTo>
                      <a:pt x="113" y="35"/>
                    </a:lnTo>
                    <a:lnTo>
                      <a:pt x="113" y="28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1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Line 80"/>
              <p:cNvSpPr/>
              <p:nvPr/>
            </p:nvSpPr>
            <p:spPr>
              <a:xfrm>
                <a:off x="3297240" y="4535640"/>
                <a:ext cx="87120" cy="1440"/>
              </a:xfrm>
              <a:prstGeom prst="line">
                <a:avLst/>
              </a:prstGeom>
              <a:ln w="0">
                <a:solidFill>
                  <a:srgbClr val="008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1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Line 88"/>
              <p:cNvSpPr/>
              <p:nvPr/>
            </p:nvSpPr>
            <p:spPr>
              <a:xfrm>
                <a:off x="3297240" y="4535640"/>
                <a:ext cx="87120" cy="1440"/>
              </a:xfrm>
              <a:prstGeom prst="line">
                <a:avLst/>
              </a:prstGeom>
              <a:ln w="0">
                <a:solidFill>
                  <a:srgbClr val="008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1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Line 96"/>
              <p:cNvSpPr/>
              <p:nvPr/>
            </p:nvSpPr>
            <p:spPr>
              <a:xfrm>
                <a:off x="3297240" y="4535640"/>
                <a:ext cx="87120" cy="1440"/>
              </a:xfrm>
              <a:prstGeom prst="line">
                <a:avLst/>
              </a:prstGeom>
              <a:ln w="0">
                <a:solidFill>
                  <a:srgbClr val="008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1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Line 104"/>
              <p:cNvSpPr/>
              <p:nvPr/>
            </p:nvSpPr>
            <p:spPr>
              <a:xfrm>
                <a:off x="3297240" y="4535640"/>
                <a:ext cx="87120" cy="1440"/>
              </a:xfrm>
              <a:prstGeom prst="line">
                <a:avLst/>
              </a:prstGeom>
              <a:ln w="0">
                <a:solidFill>
                  <a:srgbClr val="008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1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13" name="Rectangle 49"/>
            <p:cNvSpPr/>
            <p:nvPr/>
          </p:nvSpPr>
          <p:spPr>
            <a:xfrm>
              <a:off x="4911120" y="4505400"/>
              <a:ext cx="270360" cy="647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Straight Connector 73"/>
            <p:cNvSpPr/>
            <p:nvPr/>
          </p:nvSpPr>
          <p:spPr>
            <a:xfrm>
              <a:off x="3189960" y="4575240"/>
              <a:ext cx="0" cy="3603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Straight Connector 74"/>
            <p:cNvSpPr/>
            <p:nvPr/>
          </p:nvSpPr>
          <p:spPr>
            <a:xfrm>
              <a:off x="3243600" y="5151600"/>
              <a:ext cx="48600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TextBox 7"/>
            <p:cNvSpPr/>
            <p:nvPr/>
          </p:nvSpPr>
          <p:spPr>
            <a:xfrm>
              <a:off x="3092400" y="5079960"/>
              <a:ext cx="746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 min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TextBox 165"/>
            <p:cNvSpPr/>
            <p:nvPr/>
          </p:nvSpPr>
          <p:spPr>
            <a:xfrm rot="16200000">
              <a:off x="2666880" y="4575240"/>
              <a:ext cx="764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0 pA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18" name="Rectangle 135"/>
          <p:cNvSpPr/>
          <p:nvPr/>
        </p:nvSpPr>
        <p:spPr>
          <a:xfrm>
            <a:off x="2673000" y="34592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0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08:21:20Z</dcterms:created>
  <dc:creator>Michael Shattock</dc:creator>
  <dc:description/>
  <dc:language>en-US</dc:language>
  <cp:lastModifiedBy>Davor Pavlovic</cp:lastModifiedBy>
  <cp:lastPrinted>2012-05-03T14:40:06Z</cp:lastPrinted>
  <dcterms:modified xsi:type="dcterms:W3CDTF">2013-03-10T22:26:49Z</dcterms:modified>
  <cp:revision>295</cp:revision>
  <dc:subject/>
  <dc:title>PowerPoint Presentation</dc:title>
</cp:coreProperties>
</file>